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9144000" cy="6858000" type="screen4x3"/>
  <p:notesSz cx="6858000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8777" autoAdjust="0"/>
    <p:restoredTop sz="99264" autoAdjust="0"/>
  </p:normalViewPr>
  <p:slideViewPr>
    <p:cSldViewPr>
      <p:cViewPr varScale="1">
        <p:scale>
          <a:sx n="98" d="100"/>
          <a:sy n="98" d="100"/>
        </p:scale>
        <p:origin x="-821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5_5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FST'!$AC$176</c:f>
              <c:strCache>
                <c:ptCount val="1"/>
                <c:pt idx="0">
                  <c:v>HMEC NORMA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FST'!$AD$175:$AF$175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FST'!$AD$176:$AF$176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FST'!$AC$177</c:f>
              <c:strCache>
                <c:ptCount val="1"/>
                <c:pt idx="0">
                  <c:v>ADSC NORMA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AD$182:$AF$182</c:f>
                <c:numCache>
                  <c:formatCode>General</c:formatCode>
                  <c:ptCount val="3"/>
                  <c:pt idx="0">
                    <c:v>6.2049709706875884</c:v>
                  </c:pt>
                  <c:pt idx="1">
                    <c:v>1.2680984489573064</c:v>
                  </c:pt>
                  <c:pt idx="2">
                    <c:v>0.65189531439083825</c:v>
                  </c:pt>
                </c:numCache>
              </c:numRef>
            </c:plus>
            <c:minus>
              <c:numRef>
                <c:f>'ADSC FST'!$AD$182:$AF$182</c:f>
                <c:numCache>
                  <c:formatCode>General</c:formatCode>
                  <c:ptCount val="3"/>
                  <c:pt idx="0">
                    <c:v>6.2049709706875884</c:v>
                  </c:pt>
                  <c:pt idx="1">
                    <c:v>1.2680984489573064</c:v>
                  </c:pt>
                  <c:pt idx="2">
                    <c:v>0.65189531439083825</c:v>
                  </c:pt>
                </c:numCache>
              </c:numRef>
            </c:minus>
          </c:errBars>
          <c:cat>
            <c:strRef>
              <c:f>'ADSC FST'!$AD$175:$AF$175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FST'!$AD$177:$AF$177</c:f>
              <c:numCache>
                <c:formatCode>General</c:formatCode>
                <c:ptCount val="3"/>
                <c:pt idx="0">
                  <c:v>56.710446440635394</c:v>
                </c:pt>
                <c:pt idx="1">
                  <c:v>9.3217132009486825</c:v>
                </c:pt>
                <c:pt idx="2">
                  <c:v>2.5866662806901108</c:v>
                </c:pt>
              </c:numCache>
            </c:numRef>
          </c:val>
        </c:ser>
        <c:ser>
          <c:idx val="2"/>
          <c:order val="2"/>
          <c:tx>
            <c:strRef>
              <c:f>'ADSC FST'!$AC$178</c:f>
              <c:strCache>
                <c:ptCount val="1"/>
                <c:pt idx="0">
                  <c:v>MES NORMA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AD$183:$AF$183</c:f>
                <c:numCache>
                  <c:formatCode>General</c:formatCode>
                  <c:ptCount val="3"/>
                  <c:pt idx="0">
                    <c:v>0.97560595735100497</c:v>
                  </c:pt>
                  <c:pt idx="1">
                    <c:v>0.2621281403996531</c:v>
                  </c:pt>
                  <c:pt idx="2">
                    <c:v>1.7493375281485266</c:v>
                  </c:pt>
                </c:numCache>
              </c:numRef>
            </c:plus>
            <c:minus>
              <c:numRef>
                <c:f>'ADSC FST'!$AD$183:$AF$183</c:f>
                <c:numCache>
                  <c:formatCode>General</c:formatCode>
                  <c:ptCount val="3"/>
                  <c:pt idx="0">
                    <c:v>0.97560595735100497</c:v>
                  </c:pt>
                  <c:pt idx="1">
                    <c:v>0.2621281403996531</c:v>
                  </c:pt>
                  <c:pt idx="2">
                    <c:v>1.7493375281485266</c:v>
                  </c:pt>
                </c:numCache>
              </c:numRef>
            </c:minus>
          </c:errBars>
          <c:cat>
            <c:strRef>
              <c:f>'ADSC FST'!$AD$175:$AF$175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FST'!$AD$178:$AF$178</c:f>
              <c:numCache>
                <c:formatCode>General</c:formatCode>
                <c:ptCount val="3"/>
                <c:pt idx="0">
                  <c:v>15.878854866563046</c:v>
                </c:pt>
                <c:pt idx="1">
                  <c:v>1.4343414109291084</c:v>
                </c:pt>
                <c:pt idx="2">
                  <c:v>5.26040654443341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379520"/>
        <c:axId val="148381056"/>
      </c:barChart>
      <c:catAx>
        <c:axId val="148379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381056"/>
        <c:crosses val="autoZero"/>
        <c:auto val="1"/>
        <c:lblAlgn val="ctr"/>
        <c:lblOffset val="100"/>
        <c:noMultiLvlLbl val="0"/>
      </c:catAx>
      <c:valAx>
        <c:axId val="14838105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3795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7509515039901783E-2"/>
          <c:y val="0.13348348348348349"/>
          <c:w val="0.94105095150399021"/>
          <c:h val="0.656947447447447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DSC SLA'!$P$164</c:f>
              <c:strCache>
                <c:ptCount val="1"/>
                <c:pt idx="0">
                  <c:v>HMEC NORMA2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SLA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SLA'!$Q$164:$AE$164</c:f>
              <c:numCache>
                <c:formatCode>General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SLA'!$P$165</c:f>
              <c:strCache>
                <c:ptCount val="1"/>
                <c:pt idx="0">
                  <c:v>ADSC NORMA2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Q$169:$AE$169</c:f>
                <c:numCache>
                  <c:formatCode>General</c:formatCode>
                  <c:ptCount val="15"/>
                  <c:pt idx="0">
                    <c:v>0.28122571037323379</c:v>
                  </c:pt>
                  <c:pt idx="1">
                    <c:v>8.1737155431395574E-4</c:v>
                  </c:pt>
                  <c:pt idx="2">
                    <c:v>1.3657591428090594E-2</c:v>
                  </c:pt>
                  <c:pt idx="3">
                    <c:v>3.4254975687981934E-3</c:v>
                  </c:pt>
                  <c:pt idx="4">
                    <c:v>1.0774084701274118</c:v>
                  </c:pt>
                  <c:pt idx="5">
                    <c:v>1.4603234120535866E-5</c:v>
                  </c:pt>
                  <c:pt idx="6">
                    <c:v>0.11575036203284218</c:v>
                  </c:pt>
                  <c:pt idx="7">
                    <c:v>4.4225402889579338E-2</c:v>
                  </c:pt>
                  <c:pt idx="8">
                    <c:v>1.7878931337064006E-3</c:v>
                  </c:pt>
                  <c:pt idx="9">
                    <c:v>0.81799103572762333</c:v>
                  </c:pt>
                  <c:pt idx="10">
                    <c:v>2.7026575632340132E-2</c:v>
                  </c:pt>
                  <c:pt idx="11">
                    <c:v>0.12505096630326348</c:v>
                  </c:pt>
                  <c:pt idx="12">
                    <c:v>1.1815473987013779E-4</c:v>
                  </c:pt>
                  <c:pt idx="13">
                    <c:v>1.3574193786127493E-2</c:v>
                  </c:pt>
                  <c:pt idx="14">
                    <c:v>0.66188365367877044</c:v>
                  </c:pt>
                </c:numCache>
              </c:numRef>
            </c:plus>
            <c:minus>
              <c:numRef>
                <c:f>'ADSC SLA'!$Q$169:$AE$169</c:f>
                <c:numCache>
                  <c:formatCode>General</c:formatCode>
                  <c:ptCount val="15"/>
                  <c:pt idx="0">
                    <c:v>0.28122571037323379</c:v>
                  </c:pt>
                  <c:pt idx="1">
                    <c:v>8.1737155431395574E-4</c:v>
                  </c:pt>
                  <c:pt idx="2">
                    <c:v>1.3657591428090594E-2</c:v>
                  </c:pt>
                  <c:pt idx="3">
                    <c:v>3.4254975687981934E-3</c:v>
                  </c:pt>
                  <c:pt idx="4">
                    <c:v>1.0774084701274118</c:v>
                  </c:pt>
                  <c:pt idx="5">
                    <c:v>1.4603234120535866E-5</c:v>
                  </c:pt>
                  <c:pt idx="6">
                    <c:v>0.11575036203284218</c:v>
                  </c:pt>
                  <c:pt idx="7">
                    <c:v>4.4225402889579338E-2</c:v>
                  </c:pt>
                  <c:pt idx="8">
                    <c:v>1.7878931337064006E-3</c:v>
                  </c:pt>
                  <c:pt idx="9">
                    <c:v>0.81799103572762333</c:v>
                  </c:pt>
                  <c:pt idx="10">
                    <c:v>2.7026575632340132E-2</c:v>
                  </c:pt>
                  <c:pt idx="11">
                    <c:v>0.12505096630326348</c:v>
                  </c:pt>
                  <c:pt idx="12">
                    <c:v>1.1815473987013779E-4</c:v>
                  </c:pt>
                  <c:pt idx="13">
                    <c:v>1.3574193786127493E-2</c:v>
                  </c:pt>
                  <c:pt idx="14">
                    <c:v>0.66188365367877044</c:v>
                  </c:pt>
                </c:numCache>
              </c:numRef>
            </c:minus>
          </c:errBars>
          <c:cat>
            <c:strRef>
              <c:f>'ADSC SLA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SLA'!$Q$165:$AE$165</c:f>
              <c:numCache>
                <c:formatCode>General</c:formatCode>
                <c:ptCount val="15"/>
                <c:pt idx="0">
                  <c:v>1.045037450201864</c:v>
                </c:pt>
                <c:pt idx="1">
                  <c:v>4.0706779382072992E-3</c:v>
                </c:pt>
                <c:pt idx="2">
                  <c:v>4.4465818586179429E-2</c:v>
                </c:pt>
                <c:pt idx="3">
                  <c:v>6.2256300877414792E-3</c:v>
                </c:pt>
                <c:pt idx="4">
                  <c:v>4.8735894181556878</c:v>
                </c:pt>
                <c:pt idx="5">
                  <c:v>2.0358558970450425E-5</c:v>
                </c:pt>
                <c:pt idx="6">
                  <c:v>0.59997276125838417</c:v>
                </c:pt>
                <c:pt idx="7">
                  <c:v>0.2034812585418129</c:v>
                </c:pt>
                <c:pt idx="8">
                  <c:v>8.0446019954343046E-3</c:v>
                </c:pt>
                <c:pt idx="9">
                  <c:v>4.9398938361938809</c:v>
                </c:pt>
                <c:pt idx="10">
                  <c:v>0.10061875564811625</c:v>
                </c:pt>
                <c:pt idx="11">
                  <c:v>0.23155972597235688</c:v>
                </c:pt>
                <c:pt idx="12">
                  <c:v>2.1798459383444522E-4</c:v>
                </c:pt>
                <c:pt idx="13">
                  <c:v>5.9149998300749185E-2</c:v>
                </c:pt>
                <c:pt idx="14">
                  <c:v>2.1979385321866705</c:v>
                </c:pt>
              </c:numCache>
            </c:numRef>
          </c:val>
        </c:ser>
        <c:ser>
          <c:idx val="2"/>
          <c:order val="2"/>
          <c:tx>
            <c:strRef>
              <c:f>'ADSC SLA'!$P$166</c:f>
              <c:strCache>
                <c:ptCount val="1"/>
                <c:pt idx="0">
                  <c:v>MES NORMA2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Q$170:$AE$170</c:f>
                <c:numCache>
                  <c:formatCode>General</c:formatCode>
                  <c:ptCount val="15"/>
                  <c:pt idx="0">
                    <c:v>7.4418010565659207E-2</c:v>
                  </c:pt>
                  <c:pt idx="1">
                    <c:v>7.0402985928700234E-3</c:v>
                  </c:pt>
                  <c:pt idx="2">
                    <c:v>1.1009909411533903E-3</c:v>
                  </c:pt>
                  <c:pt idx="3">
                    <c:v>7.1612366964367369E-3</c:v>
                  </c:pt>
                  <c:pt idx="4">
                    <c:v>0.43469818777241792</c:v>
                  </c:pt>
                  <c:pt idx="5">
                    <c:v>4.7910135234866083E-4</c:v>
                  </c:pt>
                  <c:pt idx="6">
                    <c:v>6.5439550246805716E-3</c:v>
                  </c:pt>
                  <c:pt idx="7">
                    <c:v>9.7809553955940289E-3</c:v>
                  </c:pt>
                  <c:pt idx="8">
                    <c:v>1.2826661826610638E-3</c:v>
                  </c:pt>
                  <c:pt idx="9">
                    <c:v>3.6564263001090213E-3</c:v>
                  </c:pt>
                  <c:pt idx="10">
                    <c:v>3.0025965448698382E-2</c:v>
                  </c:pt>
                  <c:pt idx="11">
                    <c:v>3.163380399159977E-2</c:v>
                  </c:pt>
                  <c:pt idx="12">
                    <c:v>2.0551042744173253E-2</c:v>
                  </c:pt>
                  <c:pt idx="13">
                    <c:v>9.2709009968175904E-4</c:v>
                  </c:pt>
                  <c:pt idx="14">
                    <c:v>5.1367607208381702E-3</c:v>
                  </c:pt>
                </c:numCache>
              </c:numRef>
            </c:plus>
            <c:minus>
              <c:numRef>
                <c:f>'ADSC SLA'!$Q$170:$AE$170</c:f>
                <c:numCache>
                  <c:formatCode>General</c:formatCode>
                  <c:ptCount val="15"/>
                  <c:pt idx="0">
                    <c:v>7.4418010565659207E-2</c:v>
                  </c:pt>
                  <c:pt idx="1">
                    <c:v>7.0402985928700234E-3</c:v>
                  </c:pt>
                  <c:pt idx="2">
                    <c:v>1.1009909411533903E-3</c:v>
                  </c:pt>
                  <c:pt idx="3">
                    <c:v>7.1612366964367369E-3</c:v>
                  </c:pt>
                  <c:pt idx="4">
                    <c:v>0.43469818777241792</c:v>
                  </c:pt>
                  <c:pt idx="5">
                    <c:v>4.7910135234866083E-4</c:v>
                  </c:pt>
                  <c:pt idx="6">
                    <c:v>6.5439550246805716E-3</c:v>
                  </c:pt>
                  <c:pt idx="7">
                    <c:v>9.7809553955940289E-3</c:v>
                  </c:pt>
                  <c:pt idx="8">
                    <c:v>1.2826661826610638E-3</c:v>
                  </c:pt>
                  <c:pt idx="9">
                    <c:v>3.6564263001090213E-3</c:v>
                  </c:pt>
                  <c:pt idx="10">
                    <c:v>3.0025965448698382E-2</c:v>
                  </c:pt>
                  <c:pt idx="11">
                    <c:v>3.163380399159977E-2</c:v>
                  </c:pt>
                  <c:pt idx="12">
                    <c:v>2.0551042744173253E-2</c:v>
                  </c:pt>
                  <c:pt idx="13">
                    <c:v>9.2709009968175904E-4</c:v>
                  </c:pt>
                  <c:pt idx="14">
                    <c:v>5.1367607208381702E-3</c:v>
                  </c:pt>
                </c:numCache>
              </c:numRef>
            </c:minus>
          </c:errBars>
          <c:cat>
            <c:strRef>
              <c:f>'ADSC SLA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SLA'!$Q$166:$AE$166</c:f>
              <c:numCache>
                <c:formatCode>General</c:formatCode>
                <c:ptCount val="15"/>
                <c:pt idx="0">
                  <c:v>0.31355484719264098</c:v>
                </c:pt>
                <c:pt idx="1">
                  <c:v>2.9586373336753551E-2</c:v>
                </c:pt>
                <c:pt idx="2">
                  <c:v>2.165644518685274E-3</c:v>
                </c:pt>
                <c:pt idx="3">
                  <c:v>3.2361999426422039E-2</c:v>
                </c:pt>
                <c:pt idx="4">
                  <c:v>2.178671518392433</c:v>
                </c:pt>
                <c:pt idx="5">
                  <c:v>4.161542178957177E-3</c:v>
                </c:pt>
                <c:pt idx="6">
                  <c:v>2.5256788193156656E-2</c:v>
                </c:pt>
                <c:pt idx="7">
                  <c:v>9.945566909824978E-2</c:v>
                </c:pt>
                <c:pt idx="8">
                  <c:v>9.0730340560248261E-3</c:v>
                </c:pt>
                <c:pt idx="9">
                  <c:v>3.2240373554834827E-2</c:v>
                </c:pt>
                <c:pt idx="10">
                  <c:v>0.12555995317482613</c:v>
                </c:pt>
                <c:pt idx="11">
                  <c:v>9.5955490853035494E-2</c:v>
                </c:pt>
                <c:pt idx="12">
                  <c:v>8.8514111103412188E-2</c:v>
                </c:pt>
                <c:pt idx="13">
                  <c:v>1.4670050242762854E-2</c:v>
                </c:pt>
                <c:pt idx="14">
                  <c:v>0.483022470310427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047552"/>
        <c:axId val="149078016"/>
      </c:barChart>
      <c:catAx>
        <c:axId val="149047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9078016"/>
        <c:crosses val="autoZero"/>
        <c:auto val="1"/>
        <c:lblAlgn val="ctr"/>
        <c:lblOffset val="100"/>
        <c:noMultiLvlLbl val="0"/>
      </c:catAx>
      <c:valAx>
        <c:axId val="1490780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9047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PS'!$P$164</c:f>
              <c:strCache>
                <c:ptCount val="1"/>
                <c:pt idx="0">
                  <c:v>HMEC IFDUC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PS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PS'!$Q$164:$AE$164</c:f>
              <c:numCache>
                <c:formatCode>General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PS'!$P$165</c:f>
              <c:strCache>
                <c:ptCount val="1"/>
                <c:pt idx="0">
                  <c:v>ADSC  IF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Q$169:$AE$169</c:f>
                <c:numCache>
                  <c:formatCode>General</c:formatCode>
                  <c:ptCount val="15"/>
                  <c:pt idx="0">
                    <c:v>2.0605536208540109</c:v>
                  </c:pt>
                  <c:pt idx="1">
                    <c:v>6.1452104384401114E-4</c:v>
                  </c:pt>
                  <c:pt idx="2">
                    <c:v>1.5931599569750507E-3</c:v>
                  </c:pt>
                  <c:pt idx="3">
                    <c:v>4.2465048245492914E-4</c:v>
                  </c:pt>
                  <c:pt idx="4">
                    <c:v>0.68551233043632354</c:v>
                  </c:pt>
                  <c:pt idx="5">
                    <c:v>5.9716219295454129E-6</c:v>
                  </c:pt>
                  <c:pt idx="6">
                    <c:v>0.15978429979237349</c:v>
                  </c:pt>
                  <c:pt idx="7">
                    <c:v>9.1507910411066234E-3</c:v>
                  </c:pt>
                  <c:pt idx="8">
                    <c:v>3.2324336952679417E-4</c:v>
                  </c:pt>
                  <c:pt idx="9">
                    <c:v>0.60185706386246307</c:v>
                  </c:pt>
                  <c:pt idx="10">
                    <c:v>0.28246413856515523</c:v>
                  </c:pt>
                  <c:pt idx="11">
                    <c:v>0.12467793226017738</c:v>
                  </c:pt>
                  <c:pt idx="12">
                    <c:v>1.5839676116812909E-4</c:v>
                  </c:pt>
                  <c:pt idx="13">
                    <c:v>4.8373829303673154E-4</c:v>
                  </c:pt>
                  <c:pt idx="14">
                    <c:v>1.0880687932978512</c:v>
                  </c:pt>
                </c:numCache>
              </c:numRef>
            </c:plus>
            <c:minus>
              <c:numRef>
                <c:f>'ADSC PS'!$Q$169:$AE$169</c:f>
                <c:numCache>
                  <c:formatCode>General</c:formatCode>
                  <c:ptCount val="15"/>
                  <c:pt idx="0">
                    <c:v>2.0605536208540109</c:v>
                  </c:pt>
                  <c:pt idx="1">
                    <c:v>6.1452104384401114E-4</c:v>
                  </c:pt>
                  <c:pt idx="2">
                    <c:v>1.5931599569750507E-3</c:v>
                  </c:pt>
                  <c:pt idx="3">
                    <c:v>4.2465048245492914E-4</c:v>
                  </c:pt>
                  <c:pt idx="4">
                    <c:v>0.68551233043632354</c:v>
                  </c:pt>
                  <c:pt idx="5">
                    <c:v>5.9716219295454129E-6</c:v>
                  </c:pt>
                  <c:pt idx="6">
                    <c:v>0.15978429979237349</c:v>
                  </c:pt>
                  <c:pt idx="7">
                    <c:v>9.1507910411066234E-3</c:v>
                  </c:pt>
                  <c:pt idx="8">
                    <c:v>3.2324336952679417E-4</c:v>
                  </c:pt>
                  <c:pt idx="9">
                    <c:v>0.60185706386246307</c:v>
                  </c:pt>
                  <c:pt idx="10">
                    <c:v>0.28246413856515523</c:v>
                  </c:pt>
                  <c:pt idx="11">
                    <c:v>0.12467793226017738</c:v>
                  </c:pt>
                  <c:pt idx="12">
                    <c:v>1.5839676116812909E-4</c:v>
                  </c:pt>
                  <c:pt idx="13">
                    <c:v>4.8373829303673154E-4</c:v>
                  </c:pt>
                  <c:pt idx="14">
                    <c:v>1.0880687932978512</c:v>
                  </c:pt>
                </c:numCache>
              </c:numRef>
            </c:minus>
          </c:errBars>
          <c:cat>
            <c:strRef>
              <c:f>'ADSC PS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PS'!$Q$165:$AE$165</c:f>
              <c:numCache>
                <c:formatCode>General</c:formatCode>
                <c:ptCount val="15"/>
                <c:pt idx="0">
                  <c:v>15.94446946717745</c:v>
                </c:pt>
                <c:pt idx="1">
                  <c:v>7.8774769860905942E-3</c:v>
                </c:pt>
                <c:pt idx="2">
                  <c:v>7.1843229066623918E-3</c:v>
                </c:pt>
                <c:pt idx="3">
                  <c:v>2.2692096398187062E-3</c:v>
                </c:pt>
                <c:pt idx="4">
                  <c:v>4.3205055630967326</c:v>
                </c:pt>
                <c:pt idx="5">
                  <c:v>3.0248373877458462E-5</c:v>
                </c:pt>
                <c:pt idx="6">
                  <c:v>0.63589094967522819</c:v>
                </c:pt>
                <c:pt idx="7">
                  <c:v>6.2230638256134063E-2</c:v>
                </c:pt>
                <c:pt idx="8">
                  <c:v>2.6583994198834931E-3</c:v>
                </c:pt>
                <c:pt idx="9">
                  <c:v>3.9294019723143627</c:v>
                </c:pt>
                <c:pt idx="10">
                  <c:v>2.1124932706727009</c:v>
                </c:pt>
                <c:pt idx="11">
                  <c:v>0.6185314916509379</c:v>
                </c:pt>
                <c:pt idx="12">
                  <c:v>4.5451956432007875E-4</c:v>
                </c:pt>
                <c:pt idx="13">
                  <c:v>3.6023701352817096E-3</c:v>
                </c:pt>
                <c:pt idx="14">
                  <c:v>2.6292899873057474</c:v>
                </c:pt>
              </c:numCache>
            </c:numRef>
          </c:val>
        </c:ser>
        <c:ser>
          <c:idx val="2"/>
          <c:order val="2"/>
          <c:tx>
            <c:strRef>
              <c:f>'ADSC PS'!$P$166</c:f>
              <c:strCache>
                <c:ptCount val="1"/>
                <c:pt idx="0">
                  <c:v>MES IF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Q$170:$AE$170</c:f>
                <c:numCache>
                  <c:formatCode>General</c:formatCode>
                  <c:ptCount val="15"/>
                  <c:pt idx="0">
                    <c:v>1.5747577176874175</c:v>
                  </c:pt>
                  <c:pt idx="1">
                    <c:v>0.23118672514906363</c:v>
                  </c:pt>
                  <c:pt idx="2">
                    <c:v>8.8839768172592883E-4</c:v>
                  </c:pt>
                  <c:pt idx="3">
                    <c:v>3.1499631094458136E-2</c:v>
                  </c:pt>
                  <c:pt idx="4">
                    <c:v>1.4401479763217253</c:v>
                  </c:pt>
                  <c:pt idx="5">
                    <c:v>1.0272108125862552E-3</c:v>
                  </c:pt>
                  <c:pt idx="6">
                    <c:v>1.5902168843779044E-3</c:v>
                  </c:pt>
                  <c:pt idx="7">
                    <c:v>5.121686282078851E-3</c:v>
                  </c:pt>
                  <c:pt idx="8">
                    <c:v>1.4272016975758862E-4</c:v>
                  </c:pt>
                  <c:pt idx="9">
                    <c:v>0.10226472686991128</c:v>
                  </c:pt>
                  <c:pt idx="10">
                    <c:v>8.8500930093721897E-2</c:v>
                  </c:pt>
                  <c:pt idx="11">
                    <c:v>0.31354597152680019</c:v>
                  </c:pt>
                  <c:pt idx="12">
                    <c:v>1.7884667255697513E-3</c:v>
                  </c:pt>
                  <c:pt idx="13">
                    <c:v>2.9989250919756523E-3</c:v>
                  </c:pt>
                  <c:pt idx="14">
                    <c:v>2.0547854085253872</c:v>
                  </c:pt>
                </c:numCache>
              </c:numRef>
            </c:plus>
            <c:minus>
              <c:numRef>
                <c:f>'ADSC PS'!$Q$170:$AE$170</c:f>
                <c:numCache>
                  <c:formatCode>General</c:formatCode>
                  <c:ptCount val="15"/>
                  <c:pt idx="0">
                    <c:v>1.5747577176874175</c:v>
                  </c:pt>
                  <c:pt idx="1">
                    <c:v>0.23118672514906363</c:v>
                  </c:pt>
                  <c:pt idx="2">
                    <c:v>8.8839768172592883E-4</c:v>
                  </c:pt>
                  <c:pt idx="3">
                    <c:v>3.1499631094458136E-2</c:v>
                  </c:pt>
                  <c:pt idx="4">
                    <c:v>1.4401479763217253</c:v>
                  </c:pt>
                  <c:pt idx="5">
                    <c:v>1.0272108125862552E-3</c:v>
                  </c:pt>
                  <c:pt idx="6">
                    <c:v>1.5902168843779044E-3</c:v>
                  </c:pt>
                  <c:pt idx="7">
                    <c:v>5.121686282078851E-3</c:v>
                  </c:pt>
                  <c:pt idx="8">
                    <c:v>1.4272016975758862E-4</c:v>
                  </c:pt>
                  <c:pt idx="9">
                    <c:v>0.10226472686991128</c:v>
                  </c:pt>
                  <c:pt idx="10">
                    <c:v>8.8500930093721897E-2</c:v>
                  </c:pt>
                  <c:pt idx="11">
                    <c:v>0.31354597152680019</c:v>
                  </c:pt>
                  <c:pt idx="12">
                    <c:v>1.7884667255697513E-3</c:v>
                  </c:pt>
                  <c:pt idx="13">
                    <c:v>2.9989250919756523E-3</c:v>
                  </c:pt>
                  <c:pt idx="14">
                    <c:v>2.0547854085253872</c:v>
                  </c:pt>
                </c:numCache>
              </c:numRef>
            </c:minus>
          </c:errBars>
          <c:cat>
            <c:strRef>
              <c:f>'ADSC PS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PS'!$Q$166:$AE$166</c:f>
              <c:numCache>
                <c:formatCode>General</c:formatCode>
                <c:ptCount val="15"/>
                <c:pt idx="0">
                  <c:v>17.456845823062242</c:v>
                </c:pt>
                <c:pt idx="1">
                  <c:v>1.1728661492890129</c:v>
                </c:pt>
                <c:pt idx="2">
                  <c:v>4.5747285588763195E-3</c:v>
                </c:pt>
                <c:pt idx="3">
                  <c:v>7.2258548743140139E-2</c:v>
                </c:pt>
                <c:pt idx="4">
                  <c:v>10.402847902770823</c:v>
                </c:pt>
                <c:pt idx="5">
                  <c:v>4.3094820916862904E-3</c:v>
                </c:pt>
                <c:pt idx="6">
                  <c:v>3.6306095723011799E-3</c:v>
                </c:pt>
                <c:pt idx="7">
                  <c:v>0.14016942571867289</c:v>
                </c:pt>
                <c:pt idx="8">
                  <c:v>3.4809869628715172E-4</c:v>
                </c:pt>
                <c:pt idx="9">
                  <c:v>0.44709846950780313</c:v>
                </c:pt>
                <c:pt idx="10">
                  <c:v>14.453903913430411</c:v>
                </c:pt>
                <c:pt idx="11">
                  <c:v>1.4520524462627395</c:v>
                </c:pt>
                <c:pt idx="12">
                  <c:v>4.1349946074818568E-3</c:v>
                </c:pt>
                <c:pt idx="13">
                  <c:v>8.4263903974766321E-3</c:v>
                </c:pt>
                <c:pt idx="14">
                  <c:v>8.55222840215603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399616"/>
        <c:axId val="148401152"/>
      </c:barChart>
      <c:catAx>
        <c:axId val="148399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401152"/>
        <c:crosses val="autoZero"/>
        <c:auto val="1"/>
        <c:lblAlgn val="ctr"/>
        <c:lblOffset val="100"/>
        <c:noMultiLvlLbl val="0"/>
      </c:catAx>
      <c:valAx>
        <c:axId val="1484011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3996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PS'!$AB$179</c:f>
              <c:strCache>
                <c:ptCount val="1"/>
                <c:pt idx="0">
                  <c:v>HMEC IFDUC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PS'!$AC$178:$AE$178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PS'!$AC$179:$AE$179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PS'!$AB$180</c:f>
              <c:strCache>
                <c:ptCount val="1"/>
                <c:pt idx="0">
                  <c:v>ADSC  IF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AC$188:$AE$188</c:f>
                <c:numCache>
                  <c:formatCode>General</c:formatCode>
                  <c:ptCount val="3"/>
                  <c:pt idx="0">
                    <c:v>13.497418626435271</c:v>
                  </c:pt>
                  <c:pt idx="1">
                    <c:v>2.7061560429694786</c:v>
                  </c:pt>
                  <c:pt idx="2">
                    <c:v>0.23450099911324274</c:v>
                  </c:pt>
                </c:numCache>
              </c:numRef>
            </c:plus>
            <c:minus>
              <c:numRef>
                <c:f>'ADSC PS'!$AC$188:$AE$188</c:f>
                <c:numCache>
                  <c:formatCode>General</c:formatCode>
                  <c:ptCount val="3"/>
                  <c:pt idx="0">
                    <c:v>13.497418626435271</c:v>
                  </c:pt>
                  <c:pt idx="1">
                    <c:v>2.7061560429694786</c:v>
                  </c:pt>
                  <c:pt idx="2">
                    <c:v>0.23450099911324274</c:v>
                  </c:pt>
                </c:numCache>
              </c:numRef>
            </c:minus>
          </c:errBars>
          <c:cat>
            <c:strRef>
              <c:f>'ADSC PS'!$AC$178:$AE$178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PS'!$AC$180:$AE$180</c:f>
              <c:numCache>
                <c:formatCode>General</c:formatCode>
                <c:ptCount val="3"/>
                <c:pt idx="0">
                  <c:v>31.980133183010121</c:v>
                </c:pt>
                <c:pt idx="1">
                  <c:v>9.0851168194570899</c:v>
                </c:pt>
                <c:pt idx="2">
                  <c:v>1.0105460638208179</c:v>
                </c:pt>
              </c:numCache>
            </c:numRef>
          </c:val>
        </c:ser>
        <c:ser>
          <c:idx val="2"/>
          <c:order val="2"/>
          <c:tx>
            <c:strRef>
              <c:f>'ADSC PS'!$AB$181</c:f>
              <c:strCache>
                <c:ptCount val="1"/>
                <c:pt idx="0">
                  <c:v>MES IF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AC$189:$AE$189</c:f>
                <c:numCache>
                  <c:formatCode>General</c:formatCode>
                  <c:ptCount val="3"/>
                  <c:pt idx="0">
                    <c:v>1.8466908857783684</c:v>
                  </c:pt>
                  <c:pt idx="1">
                    <c:v>0.79879639461936081</c:v>
                  </c:pt>
                  <c:pt idx="2">
                    <c:v>1.8805524741454354</c:v>
                  </c:pt>
                </c:numCache>
              </c:numRef>
            </c:plus>
            <c:minus>
              <c:numRef>
                <c:f>'ADSC PS'!$AC$189:$AE$189</c:f>
                <c:numCache>
                  <c:formatCode>General</c:formatCode>
                  <c:ptCount val="3"/>
                  <c:pt idx="0">
                    <c:v>1.8466908857783684</c:v>
                  </c:pt>
                  <c:pt idx="1">
                    <c:v>0.79879639461936081</c:v>
                  </c:pt>
                  <c:pt idx="2">
                    <c:v>1.8805524741454354</c:v>
                  </c:pt>
                </c:numCache>
              </c:numRef>
            </c:minus>
          </c:errBars>
          <c:cat>
            <c:strRef>
              <c:f>'ADSC PS'!$AC$178:$AE$178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PS'!$AC$181:$AE$181</c:f>
              <c:numCache>
                <c:formatCode>General</c:formatCode>
                <c:ptCount val="3"/>
                <c:pt idx="0">
                  <c:v>115.90423814934915</c:v>
                </c:pt>
                <c:pt idx="1">
                  <c:v>4.6015684668583683</c:v>
                </c:pt>
                <c:pt idx="2">
                  <c:v>35.2950669333930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427904"/>
        <c:axId val="148429440"/>
      </c:barChart>
      <c:catAx>
        <c:axId val="148427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429440"/>
        <c:crosses val="autoZero"/>
        <c:auto val="1"/>
        <c:lblAlgn val="ctr"/>
        <c:lblOffset val="100"/>
        <c:noMultiLvlLbl val="0"/>
      </c:catAx>
      <c:valAx>
        <c:axId val="1484294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4279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KB'!$AB$178</c:f>
              <c:strCache>
                <c:ptCount val="1"/>
                <c:pt idx="0">
                  <c:v>HMEC NORMA4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KB'!$AC$177:$AD$177</c:f>
              <c:strCache>
                <c:ptCount val="2"/>
                <c:pt idx="0">
                  <c:v>ACTA2</c:v>
                </c:pt>
                <c:pt idx="1">
                  <c:v>CD10</c:v>
                </c:pt>
              </c:strCache>
            </c:strRef>
          </c:cat>
          <c:val>
            <c:numRef>
              <c:f>'ADSC KB'!$AC$178:$AD$178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KB'!$AB$179</c:f>
              <c:strCache>
                <c:ptCount val="1"/>
                <c:pt idx="0">
                  <c:v>ADSC NORMA4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AC$183:$AD$183</c:f>
                <c:numCache>
                  <c:formatCode>General</c:formatCode>
                  <c:ptCount val="2"/>
                  <c:pt idx="0">
                    <c:v>18.150326287210298</c:v>
                  </c:pt>
                  <c:pt idx="1">
                    <c:v>12.986162101867711</c:v>
                  </c:pt>
                </c:numCache>
              </c:numRef>
            </c:plus>
            <c:minus>
              <c:numRef>
                <c:f>'ADSC KB'!$AC$183:$AD$183</c:f>
                <c:numCache>
                  <c:formatCode>General</c:formatCode>
                  <c:ptCount val="2"/>
                  <c:pt idx="0">
                    <c:v>18.150326287210298</c:v>
                  </c:pt>
                  <c:pt idx="1">
                    <c:v>12.986162101867711</c:v>
                  </c:pt>
                </c:numCache>
              </c:numRef>
            </c:minus>
          </c:errBars>
          <c:cat>
            <c:strRef>
              <c:f>'ADSC KB'!$AC$177:$AD$177</c:f>
              <c:strCache>
                <c:ptCount val="2"/>
                <c:pt idx="0">
                  <c:v>ACTA2</c:v>
                </c:pt>
                <c:pt idx="1">
                  <c:v>CD10</c:v>
                </c:pt>
              </c:strCache>
            </c:strRef>
          </c:cat>
          <c:val>
            <c:numRef>
              <c:f>'ADSC KB'!$AC$179:$AD$179</c:f>
              <c:numCache>
                <c:formatCode>General</c:formatCode>
                <c:ptCount val="2"/>
                <c:pt idx="0">
                  <c:v>112.63981127381658</c:v>
                </c:pt>
                <c:pt idx="1">
                  <c:v>42.879732323305383</c:v>
                </c:pt>
              </c:numCache>
            </c:numRef>
          </c:val>
        </c:ser>
        <c:ser>
          <c:idx val="2"/>
          <c:order val="2"/>
          <c:tx>
            <c:strRef>
              <c:f>'ADSC KB'!$AB$180</c:f>
              <c:strCache>
                <c:ptCount val="1"/>
                <c:pt idx="0">
                  <c:v>MES NORMA4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AC$184:$AD$184</c:f>
                <c:numCache>
                  <c:formatCode>General</c:formatCode>
                  <c:ptCount val="2"/>
                  <c:pt idx="0">
                    <c:v>40.540948924267632</c:v>
                  </c:pt>
                  <c:pt idx="1">
                    <c:v>112.99388261255351</c:v>
                  </c:pt>
                </c:numCache>
              </c:numRef>
            </c:plus>
            <c:minus>
              <c:numRef>
                <c:f>'ADSC KB'!$AC$184:$AD$184</c:f>
                <c:numCache>
                  <c:formatCode>General</c:formatCode>
                  <c:ptCount val="2"/>
                  <c:pt idx="0">
                    <c:v>40.540948924267632</c:v>
                  </c:pt>
                  <c:pt idx="1">
                    <c:v>112.99388261255351</c:v>
                  </c:pt>
                </c:numCache>
              </c:numRef>
            </c:minus>
          </c:errBars>
          <c:cat>
            <c:strRef>
              <c:f>'ADSC KB'!$AC$177:$AD$177</c:f>
              <c:strCache>
                <c:ptCount val="2"/>
                <c:pt idx="0">
                  <c:v>ACTA2</c:v>
                </c:pt>
                <c:pt idx="1">
                  <c:v>CD10</c:v>
                </c:pt>
              </c:strCache>
            </c:strRef>
          </c:cat>
          <c:val>
            <c:numRef>
              <c:f>'ADSC KB'!$AC$180:$AD$180</c:f>
              <c:numCache>
                <c:formatCode>General</c:formatCode>
                <c:ptCount val="2"/>
                <c:pt idx="0">
                  <c:v>197.53517106546744</c:v>
                </c:pt>
                <c:pt idx="1">
                  <c:v>574.83370368931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538112"/>
        <c:axId val="148539648"/>
      </c:barChart>
      <c:catAx>
        <c:axId val="148538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539648"/>
        <c:crosses val="autoZero"/>
        <c:auto val="1"/>
        <c:lblAlgn val="ctr"/>
        <c:lblOffset val="100"/>
        <c:noMultiLvlLbl val="0"/>
      </c:catAx>
      <c:valAx>
        <c:axId val="14853964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5381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KB'!$P$164</c:f>
              <c:strCache>
                <c:ptCount val="1"/>
                <c:pt idx="0">
                  <c:v>HMEC NORMA4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KB'!$Q$163:$AF$163</c:f>
              <c:strCache>
                <c:ptCount val="16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  <c:pt idx="15">
                  <c:v>CNN1</c:v>
                </c:pt>
              </c:strCache>
            </c:strRef>
          </c:cat>
          <c:val>
            <c:numRef>
              <c:f>'ADSC KB'!$Q$164:$AF$164</c:f>
              <c:numCache>
                <c:formatCode>General</c:formatCode>
                <c:ptCount val="1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KB'!$P$165</c:f>
              <c:strCache>
                <c:ptCount val="1"/>
                <c:pt idx="0">
                  <c:v>ADSC NORMA4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Q$169:$AF$169</c:f>
                <c:numCache>
                  <c:formatCode>General</c:formatCode>
                  <c:ptCount val="16"/>
                  <c:pt idx="0">
                    <c:v>0.10359931681413642</c:v>
                  </c:pt>
                  <c:pt idx="1">
                    <c:v>4.4412369793170612E-4</c:v>
                  </c:pt>
                  <c:pt idx="2">
                    <c:v>4.2341998476092723E-4</c:v>
                  </c:pt>
                  <c:pt idx="3">
                    <c:v>2.8096179628861375E-4</c:v>
                  </c:pt>
                  <c:pt idx="4">
                    <c:v>1.1020148094226974</c:v>
                  </c:pt>
                  <c:pt idx="5">
                    <c:v>2.0366345185085374E-5</c:v>
                  </c:pt>
                  <c:pt idx="6">
                    <c:v>9.0730162586972057E-3</c:v>
                  </c:pt>
                  <c:pt idx="7">
                    <c:v>1.3123703258221743E-3</c:v>
                  </c:pt>
                  <c:pt idx="8">
                    <c:v>6.5346702561834742E-4</c:v>
                  </c:pt>
                  <c:pt idx="9">
                    <c:v>8.6325657005327197E-2</c:v>
                  </c:pt>
                  <c:pt idx="10">
                    <c:v>1.4194097985886608E-2</c:v>
                  </c:pt>
                  <c:pt idx="11">
                    <c:v>4.7787526729975105E-2</c:v>
                  </c:pt>
                  <c:pt idx="12">
                    <c:v>2.1029070563674974E-5</c:v>
                  </c:pt>
                  <c:pt idx="13">
                    <c:v>6.4814182395792853E-3</c:v>
                  </c:pt>
                  <c:pt idx="14">
                    <c:v>2.122419432382177</c:v>
                  </c:pt>
                  <c:pt idx="15">
                    <c:v>0.27462950114966928</c:v>
                  </c:pt>
                </c:numCache>
              </c:numRef>
            </c:plus>
            <c:minus>
              <c:numRef>
                <c:f>'ADSC KB'!$Q$169:$AF$169</c:f>
                <c:numCache>
                  <c:formatCode>General</c:formatCode>
                  <c:ptCount val="16"/>
                  <c:pt idx="0">
                    <c:v>0.10359931681413642</c:v>
                  </c:pt>
                  <c:pt idx="1">
                    <c:v>4.4412369793170612E-4</c:v>
                  </c:pt>
                  <c:pt idx="2">
                    <c:v>4.2341998476092723E-4</c:v>
                  </c:pt>
                  <c:pt idx="3">
                    <c:v>2.8096179628861375E-4</c:v>
                  </c:pt>
                  <c:pt idx="4">
                    <c:v>1.1020148094226974</c:v>
                  </c:pt>
                  <c:pt idx="5">
                    <c:v>2.0366345185085374E-5</c:v>
                  </c:pt>
                  <c:pt idx="6">
                    <c:v>9.0730162586972057E-3</c:v>
                  </c:pt>
                  <c:pt idx="7">
                    <c:v>1.3123703258221743E-3</c:v>
                  </c:pt>
                  <c:pt idx="8">
                    <c:v>6.5346702561834742E-4</c:v>
                  </c:pt>
                  <c:pt idx="9">
                    <c:v>8.6325657005327197E-2</c:v>
                  </c:pt>
                  <c:pt idx="10">
                    <c:v>1.4194097985886608E-2</c:v>
                  </c:pt>
                  <c:pt idx="11">
                    <c:v>4.7787526729975105E-2</c:v>
                  </c:pt>
                  <c:pt idx="12">
                    <c:v>2.1029070563674974E-5</c:v>
                  </c:pt>
                  <c:pt idx="13">
                    <c:v>6.4814182395792853E-3</c:v>
                  </c:pt>
                  <c:pt idx="14">
                    <c:v>2.122419432382177</c:v>
                  </c:pt>
                  <c:pt idx="15">
                    <c:v>0.27462950114966928</c:v>
                  </c:pt>
                </c:numCache>
              </c:numRef>
            </c:minus>
          </c:errBars>
          <c:cat>
            <c:strRef>
              <c:f>'ADSC KB'!$Q$163:$AF$163</c:f>
              <c:strCache>
                <c:ptCount val="16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  <c:pt idx="15">
                  <c:v>CNN1</c:v>
                </c:pt>
              </c:strCache>
            </c:strRef>
          </c:cat>
          <c:val>
            <c:numRef>
              <c:f>'ADSC KB'!$Q$165:$AF$165</c:f>
              <c:numCache>
                <c:formatCode>General</c:formatCode>
                <c:ptCount val="16"/>
                <c:pt idx="0">
                  <c:v>0.54168746978136417</c:v>
                </c:pt>
                <c:pt idx="1">
                  <c:v>1.8166775184536891E-3</c:v>
                </c:pt>
                <c:pt idx="2">
                  <c:v>1.0615865104377199E-3</c:v>
                </c:pt>
                <c:pt idx="3">
                  <c:v>1.1050177535965819E-3</c:v>
                </c:pt>
                <c:pt idx="4">
                  <c:v>6.3400574903351661</c:v>
                </c:pt>
                <c:pt idx="5">
                  <c:v>4.6053388577714765E-5</c:v>
                </c:pt>
                <c:pt idx="6">
                  <c:v>0.11207681112552594</c:v>
                </c:pt>
                <c:pt idx="7">
                  <c:v>1.6614750339846676E-2</c:v>
                </c:pt>
                <c:pt idx="8">
                  <c:v>5.9408518041301995E-3</c:v>
                </c:pt>
                <c:pt idx="9">
                  <c:v>0.61694346851759174</c:v>
                </c:pt>
                <c:pt idx="10">
                  <c:v>0.10931227572114026</c:v>
                </c:pt>
                <c:pt idx="11">
                  <c:v>0.28564197992360624</c:v>
                </c:pt>
                <c:pt idx="12">
                  <c:v>9.9736452673504958E-5</c:v>
                </c:pt>
                <c:pt idx="13">
                  <c:v>3.4189081569978352E-2</c:v>
                </c:pt>
                <c:pt idx="14">
                  <c:v>3.656885513517159</c:v>
                </c:pt>
                <c:pt idx="15">
                  <c:v>3.0993545445784121</c:v>
                </c:pt>
              </c:numCache>
            </c:numRef>
          </c:val>
        </c:ser>
        <c:ser>
          <c:idx val="2"/>
          <c:order val="2"/>
          <c:tx>
            <c:strRef>
              <c:f>'ADSC KB'!$P$166</c:f>
              <c:strCache>
                <c:ptCount val="1"/>
                <c:pt idx="0">
                  <c:v>MES NORMA4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Q$170:$AF$170</c:f>
                <c:numCache>
                  <c:formatCode>General</c:formatCode>
                  <c:ptCount val="16"/>
                  <c:pt idx="0">
                    <c:v>0.48172825958598425</c:v>
                  </c:pt>
                  <c:pt idx="1">
                    <c:v>5.3251661246402023E-2</c:v>
                  </c:pt>
                  <c:pt idx="2">
                    <c:v>1.578746169516464E-2</c:v>
                  </c:pt>
                  <c:pt idx="3">
                    <c:v>0.52086273957022566</c:v>
                  </c:pt>
                  <c:pt idx="4">
                    <c:v>8.5681480786534397E-2</c:v>
                  </c:pt>
                  <c:pt idx="5">
                    <c:v>1.8362948991881227E-2</c:v>
                  </c:pt>
                  <c:pt idx="6">
                    <c:v>3.3996409533057402E-2</c:v>
                  </c:pt>
                  <c:pt idx="7">
                    <c:v>0.43098685762246802</c:v>
                  </c:pt>
                  <c:pt idx="8">
                    <c:v>6.2215732081790098E-3</c:v>
                  </c:pt>
                  <c:pt idx="9">
                    <c:v>6.471206252366965E-2</c:v>
                  </c:pt>
                  <c:pt idx="10">
                    <c:v>0.32825211313309549</c:v>
                  </c:pt>
                  <c:pt idx="11">
                    <c:v>1.292464525676639E-2</c:v>
                  </c:pt>
                  <c:pt idx="12">
                    <c:v>0.55655345257557998</c:v>
                  </c:pt>
                  <c:pt idx="13">
                    <c:v>6.3691521477004737E-3</c:v>
                  </c:pt>
                  <c:pt idx="14">
                    <c:v>3.1804556984388075</c:v>
                  </c:pt>
                  <c:pt idx="15">
                    <c:v>0.50754908574036983</c:v>
                  </c:pt>
                </c:numCache>
              </c:numRef>
            </c:plus>
            <c:minus>
              <c:numRef>
                <c:f>'ADSC KB'!$Q$170:$AF$170</c:f>
                <c:numCache>
                  <c:formatCode>General</c:formatCode>
                  <c:ptCount val="16"/>
                  <c:pt idx="0">
                    <c:v>0.48172825958598425</c:v>
                  </c:pt>
                  <c:pt idx="1">
                    <c:v>5.3251661246402023E-2</c:v>
                  </c:pt>
                  <c:pt idx="2">
                    <c:v>1.578746169516464E-2</c:v>
                  </c:pt>
                  <c:pt idx="3">
                    <c:v>0.52086273957022566</c:v>
                  </c:pt>
                  <c:pt idx="4">
                    <c:v>8.5681480786534397E-2</c:v>
                  </c:pt>
                  <c:pt idx="5">
                    <c:v>1.8362948991881227E-2</c:v>
                  </c:pt>
                  <c:pt idx="6">
                    <c:v>3.3996409533057402E-2</c:v>
                  </c:pt>
                  <c:pt idx="7">
                    <c:v>0.43098685762246802</c:v>
                  </c:pt>
                  <c:pt idx="8">
                    <c:v>6.2215732081790098E-3</c:v>
                  </c:pt>
                  <c:pt idx="9">
                    <c:v>6.471206252366965E-2</c:v>
                  </c:pt>
                  <c:pt idx="10">
                    <c:v>0.32825211313309549</c:v>
                  </c:pt>
                  <c:pt idx="11">
                    <c:v>1.292464525676639E-2</c:v>
                  </c:pt>
                  <c:pt idx="12">
                    <c:v>0.55655345257557998</c:v>
                  </c:pt>
                  <c:pt idx="13">
                    <c:v>6.3691521477004737E-3</c:v>
                  </c:pt>
                  <c:pt idx="14">
                    <c:v>3.1804556984388075</c:v>
                  </c:pt>
                  <c:pt idx="15">
                    <c:v>0.50754908574036983</c:v>
                  </c:pt>
                </c:numCache>
              </c:numRef>
            </c:minus>
          </c:errBars>
          <c:cat>
            <c:strRef>
              <c:f>'ADSC KB'!$Q$163:$AF$163</c:f>
              <c:strCache>
                <c:ptCount val="16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  <c:pt idx="15">
                  <c:v>CNN1</c:v>
                </c:pt>
              </c:strCache>
            </c:strRef>
          </c:cat>
          <c:val>
            <c:numRef>
              <c:f>'ADSC KB'!$Q$166:$AF$166</c:f>
              <c:numCache>
                <c:formatCode>General</c:formatCode>
                <c:ptCount val="16"/>
                <c:pt idx="0">
                  <c:v>2.5072051527056298</c:v>
                </c:pt>
                <c:pt idx="1">
                  <c:v>0.36992901763625929</c:v>
                </c:pt>
                <c:pt idx="2">
                  <c:v>0.10044056714022838</c:v>
                </c:pt>
                <c:pt idx="3">
                  <c:v>2.3142246774544684</c:v>
                </c:pt>
                <c:pt idx="4">
                  <c:v>5.353081637823716</c:v>
                </c:pt>
                <c:pt idx="5">
                  <c:v>0.2257846232287016</c:v>
                </c:pt>
                <c:pt idx="6">
                  <c:v>0.72526607915738828</c:v>
                </c:pt>
                <c:pt idx="7">
                  <c:v>2.0974344222609957</c:v>
                </c:pt>
                <c:pt idx="8">
                  <c:v>0.24671315577479982</c:v>
                </c:pt>
                <c:pt idx="9">
                  <c:v>0.47474733855368179</c:v>
                </c:pt>
                <c:pt idx="10">
                  <c:v>4.0717577467977861</c:v>
                </c:pt>
                <c:pt idx="11">
                  <c:v>5.8494919148284842E-2</c:v>
                </c:pt>
                <c:pt idx="12">
                  <c:v>1.3612968673756078</c:v>
                </c:pt>
                <c:pt idx="13">
                  <c:v>8.5880999040068417E-3</c:v>
                </c:pt>
                <c:pt idx="14">
                  <c:v>7.3244618598402909</c:v>
                </c:pt>
                <c:pt idx="15">
                  <c:v>4.04244480697693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713856"/>
        <c:axId val="148715392"/>
      </c:barChart>
      <c:catAx>
        <c:axId val="1487138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715392"/>
        <c:crosses val="autoZero"/>
        <c:auto val="1"/>
        <c:lblAlgn val="ctr"/>
        <c:lblOffset val="100"/>
        <c:noMultiLvlLbl val="0"/>
      </c:catAx>
      <c:valAx>
        <c:axId val="14871539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7138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MBE'!$AB$177</c:f>
              <c:strCache>
                <c:ptCount val="1"/>
                <c:pt idx="0">
                  <c:v>HMEC NORMA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MBE'!$AC$176:$AE$176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MBE'!$AC$177:$AE$177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MBE'!$AB$178</c:f>
              <c:strCache>
                <c:ptCount val="1"/>
                <c:pt idx="0">
                  <c:v>ADSC NORMA3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AC$182:$AE$182</c:f>
                <c:numCache>
                  <c:formatCode>General</c:formatCode>
                  <c:ptCount val="3"/>
                  <c:pt idx="0">
                    <c:v>6.8362053471020872</c:v>
                  </c:pt>
                  <c:pt idx="1">
                    <c:v>1.4899666369239652</c:v>
                  </c:pt>
                  <c:pt idx="2">
                    <c:v>0.22372667695180398</c:v>
                  </c:pt>
                </c:numCache>
              </c:numRef>
            </c:plus>
            <c:minus>
              <c:numRef>
                <c:f>'ADSC MBE'!$AC$182:$AE$182</c:f>
                <c:numCache>
                  <c:formatCode>General</c:formatCode>
                  <c:ptCount val="3"/>
                  <c:pt idx="0">
                    <c:v>6.8362053471020872</c:v>
                  </c:pt>
                  <c:pt idx="1">
                    <c:v>1.4899666369239652</c:v>
                  </c:pt>
                  <c:pt idx="2">
                    <c:v>0.22372667695180398</c:v>
                  </c:pt>
                </c:numCache>
              </c:numRef>
            </c:minus>
          </c:errBars>
          <c:cat>
            <c:strRef>
              <c:f>'ADSC MBE'!$AC$176:$AE$176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MBE'!$AC$178:$AE$178</c:f>
              <c:numCache>
                <c:formatCode>General</c:formatCode>
                <c:ptCount val="3"/>
                <c:pt idx="0">
                  <c:v>29.428225799619351</c:v>
                </c:pt>
                <c:pt idx="1">
                  <c:v>4.0847493416995215</c:v>
                </c:pt>
                <c:pt idx="2">
                  <c:v>0.61329320096510187</c:v>
                </c:pt>
              </c:numCache>
            </c:numRef>
          </c:val>
        </c:ser>
        <c:ser>
          <c:idx val="2"/>
          <c:order val="2"/>
          <c:tx>
            <c:strRef>
              <c:f>'ADSC MBE'!$AB$179</c:f>
              <c:strCache>
                <c:ptCount val="1"/>
                <c:pt idx="0">
                  <c:v>MES NORMA3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AC$183:$AE$183</c:f>
                <c:numCache>
                  <c:formatCode>General</c:formatCode>
                  <c:ptCount val="3"/>
                  <c:pt idx="0">
                    <c:v>19.191191686286295</c:v>
                  </c:pt>
                  <c:pt idx="1">
                    <c:v>2.0082519419075515</c:v>
                  </c:pt>
                  <c:pt idx="2">
                    <c:v>4.548207425708533</c:v>
                  </c:pt>
                </c:numCache>
              </c:numRef>
            </c:plus>
            <c:minus>
              <c:numRef>
                <c:f>'ADSC MBE'!$AC$183:$AE$183</c:f>
                <c:numCache>
                  <c:formatCode>General</c:formatCode>
                  <c:ptCount val="3"/>
                  <c:pt idx="0">
                    <c:v>19.191191686286295</c:v>
                  </c:pt>
                  <c:pt idx="1">
                    <c:v>2.0082519419075515</c:v>
                  </c:pt>
                  <c:pt idx="2">
                    <c:v>4.548207425708533</c:v>
                  </c:pt>
                </c:numCache>
              </c:numRef>
            </c:minus>
          </c:errBars>
          <c:cat>
            <c:strRef>
              <c:f>'ADSC MBE'!$AC$176:$AE$176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MBE'!$AC$179:$AE$179</c:f>
              <c:numCache>
                <c:formatCode>General</c:formatCode>
                <c:ptCount val="3"/>
                <c:pt idx="0">
                  <c:v>71.775201272080707</c:v>
                </c:pt>
                <c:pt idx="1">
                  <c:v>5.1571592653515586</c:v>
                </c:pt>
                <c:pt idx="2">
                  <c:v>13.5414362734931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754432"/>
        <c:axId val="148755968"/>
      </c:barChart>
      <c:catAx>
        <c:axId val="148754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755968"/>
        <c:crosses val="autoZero"/>
        <c:auto val="1"/>
        <c:lblAlgn val="ctr"/>
        <c:lblOffset val="100"/>
        <c:noMultiLvlLbl val="0"/>
      </c:catAx>
      <c:valAx>
        <c:axId val="14875596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7544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MBE'!$P$164</c:f>
              <c:strCache>
                <c:ptCount val="1"/>
                <c:pt idx="0">
                  <c:v>HMEC NORMA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MBE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MBE'!$Q$164:$AE$164</c:f>
              <c:numCache>
                <c:formatCode>General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MBE'!$P$165</c:f>
              <c:strCache>
                <c:ptCount val="1"/>
                <c:pt idx="0">
                  <c:v>ADSC NORMA3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Q$173:$AE$173</c:f>
                <c:numCache>
                  <c:formatCode>General</c:formatCode>
                  <c:ptCount val="15"/>
                  <c:pt idx="0">
                    <c:v>4.605641536959363E-3</c:v>
                  </c:pt>
                  <c:pt idx="1">
                    <c:v>3.0370399297528616E-3</c:v>
                  </c:pt>
                  <c:pt idx="2">
                    <c:v>6.6470536090208407E-4</c:v>
                  </c:pt>
                  <c:pt idx="3">
                    <c:v>4.9948592650808871E-4</c:v>
                  </c:pt>
                  <c:pt idx="4">
                    <c:v>0.2884822672110301</c:v>
                  </c:pt>
                  <c:pt idx="5">
                    <c:v>5.2004609663010212E-7</c:v>
                  </c:pt>
                  <c:pt idx="6">
                    <c:v>1.7527412169626302E-2</c:v>
                  </c:pt>
                  <c:pt idx="7">
                    <c:v>3.720402572462804E-2</c:v>
                  </c:pt>
                  <c:pt idx="8">
                    <c:v>4.2818460628782249E-3</c:v>
                  </c:pt>
                  <c:pt idx="9">
                    <c:v>0.60302876620975232</c:v>
                  </c:pt>
                  <c:pt idx="10">
                    <c:v>0.14336632688157463</c:v>
                  </c:pt>
                  <c:pt idx="11">
                    <c:v>0.12806951481789355</c:v>
                  </c:pt>
                  <c:pt idx="12">
                    <c:v>2.1863641803731566E-3</c:v>
                  </c:pt>
                  <c:pt idx="13">
                    <c:v>5.2234987416546058E-3</c:v>
                  </c:pt>
                  <c:pt idx="14">
                    <c:v>0.20282009791414268</c:v>
                  </c:pt>
                </c:numCache>
              </c:numRef>
            </c:plus>
            <c:minus>
              <c:numRef>
                <c:f>'ADSC MBE'!$Q$173:$AE$173</c:f>
                <c:numCache>
                  <c:formatCode>General</c:formatCode>
                  <c:ptCount val="15"/>
                  <c:pt idx="0">
                    <c:v>4.605641536959363E-3</c:v>
                  </c:pt>
                  <c:pt idx="1">
                    <c:v>3.0370399297528616E-3</c:v>
                  </c:pt>
                  <c:pt idx="2">
                    <c:v>6.6470536090208407E-4</c:v>
                  </c:pt>
                  <c:pt idx="3">
                    <c:v>4.9948592650808871E-4</c:v>
                  </c:pt>
                  <c:pt idx="4">
                    <c:v>0.2884822672110301</c:v>
                  </c:pt>
                  <c:pt idx="5">
                    <c:v>5.2004609663010212E-7</c:v>
                  </c:pt>
                  <c:pt idx="6">
                    <c:v>1.7527412169626302E-2</c:v>
                  </c:pt>
                  <c:pt idx="7">
                    <c:v>3.720402572462804E-2</c:v>
                  </c:pt>
                  <c:pt idx="8">
                    <c:v>4.2818460628782249E-3</c:v>
                  </c:pt>
                  <c:pt idx="9">
                    <c:v>0.60302876620975232</c:v>
                  </c:pt>
                  <c:pt idx="10">
                    <c:v>0.14336632688157463</c:v>
                  </c:pt>
                  <c:pt idx="11">
                    <c:v>0.12806951481789355</c:v>
                  </c:pt>
                  <c:pt idx="12">
                    <c:v>2.1863641803731566E-3</c:v>
                  </c:pt>
                  <c:pt idx="13">
                    <c:v>5.2234987416546058E-3</c:v>
                  </c:pt>
                  <c:pt idx="14">
                    <c:v>0.20282009791414268</c:v>
                  </c:pt>
                </c:numCache>
              </c:numRef>
            </c:minus>
          </c:errBars>
          <c:cat>
            <c:strRef>
              <c:f>'ADSC MBE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MBE'!$Q$165:$AE$165</c:f>
              <c:numCache>
                <c:formatCode>General</c:formatCode>
                <c:ptCount val="15"/>
                <c:pt idx="0">
                  <c:v>0.15862976992996566</c:v>
                </c:pt>
                <c:pt idx="1">
                  <c:v>2.3811288111100573E-3</c:v>
                </c:pt>
                <c:pt idx="2">
                  <c:v>9.5198693823764907E-4</c:v>
                </c:pt>
                <c:pt idx="3">
                  <c:v>7.595335330942447E-4</c:v>
                </c:pt>
                <c:pt idx="4">
                  <c:v>1.9104684724287297</c:v>
                </c:pt>
                <c:pt idx="5">
                  <c:v>1.1808730151777637E-6</c:v>
                </c:pt>
                <c:pt idx="6">
                  <c:v>0.23857731869168131</c:v>
                </c:pt>
                <c:pt idx="7">
                  <c:v>7.1610549363336509E-2</c:v>
                </c:pt>
                <c:pt idx="8">
                  <c:v>1.4627572022771684E-2</c:v>
                </c:pt>
                <c:pt idx="9">
                  <c:v>0.84217383007157975</c:v>
                </c:pt>
                <c:pt idx="10">
                  <c:v>0.67188184957085306</c:v>
                </c:pt>
                <c:pt idx="11">
                  <c:v>0.30821031806807353</c:v>
                </c:pt>
                <c:pt idx="12">
                  <c:v>3.3379248054486014E-3</c:v>
                </c:pt>
                <c:pt idx="13">
                  <c:v>6.834547816544855E-3</c:v>
                </c:pt>
                <c:pt idx="14">
                  <c:v>0.68767912781508989</c:v>
                </c:pt>
              </c:numCache>
            </c:numRef>
          </c:val>
        </c:ser>
        <c:ser>
          <c:idx val="2"/>
          <c:order val="2"/>
          <c:tx>
            <c:strRef>
              <c:f>'ADSC MBE'!$P$166</c:f>
              <c:strCache>
                <c:ptCount val="1"/>
                <c:pt idx="0">
                  <c:v>MES NORMA3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Q$174:$AE$174</c:f>
                <c:numCache>
                  <c:formatCode>General</c:formatCode>
                  <c:ptCount val="15"/>
                  <c:pt idx="0">
                    <c:v>0.13349653350678128</c:v>
                  </c:pt>
                  <c:pt idx="1">
                    <c:v>5.6426857002405066E-2</c:v>
                  </c:pt>
                  <c:pt idx="2">
                    <c:v>2.9641613920270531E-3</c:v>
                  </c:pt>
                  <c:pt idx="3">
                    <c:v>1.5367518347580119E-2</c:v>
                  </c:pt>
                  <c:pt idx="4">
                    <c:v>0.32622325929664098</c:v>
                  </c:pt>
                  <c:pt idx="5">
                    <c:v>1.5701033724056533E-2</c:v>
                  </c:pt>
                  <c:pt idx="6">
                    <c:v>2.8347385660007898E-2</c:v>
                  </c:pt>
                  <c:pt idx="7">
                    <c:v>0.81264543901680009</c:v>
                  </c:pt>
                  <c:pt idx="8">
                    <c:v>7.3014712157319833E-2</c:v>
                  </c:pt>
                  <c:pt idx="9">
                    <c:v>7.1328258748443202E-2</c:v>
                  </c:pt>
                  <c:pt idx="10">
                    <c:v>8.8320503084570082E-2</c:v>
                  </c:pt>
                  <c:pt idx="11">
                    <c:v>2.9438048447093645E-2</c:v>
                  </c:pt>
                  <c:pt idx="12">
                    <c:v>5.9952414459304056E-2</c:v>
                  </c:pt>
                  <c:pt idx="13">
                    <c:v>8.8225604811423813E-3</c:v>
                  </c:pt>
                  <c:pt idx="14">
                    <c:v>9.0812550841732398E-2</c:v>
                  </c:pt>
                </c:numCache>
              </c:numRef>
            </c:plus>
            <c:minus>
              <c:numRef>
                <c:f>'ADSC MBE'!$Q$174:$AE$174</c:f>
                <c:numCache>
                  <c:formatCode>General</c:formatCode>
                  <c:ptCount val="15"/>
                  <c:pt idx="0">
                    <c:v>0.13349653350678128</c:v>
                  </c:pt>
                  <c:pt idx="1">
                    <c:v>5.6426857002405066E-2</c:v>
                  </c:pt>
                  <c:pt idx="2">
                    <c:v>2.9641613920270531E-3</c:v>
                  </c:pt>
                  <c:pt idx="3">
                    <c:v>1.5367518347580119E-2</c:v>
                  </c:pt>
                  <c:pt idx="4">
                    <c:v>0.32622325929664098</c:v>
                  </c:pt>
                  <c:pt idx="5">
                    <c:v>1.5701033724056533E-2</c:v>
                  </c:pt>
                  <c:pt idx="6">
                    <c:v>2.8347385660007898E-2</c:v>
                  </c:pt>
                  <c:pt idx="7">
                    <c:v>0.81264543901680009</c:v>
                  </c:pt>
                  <c:pt idx="8">
                    <c:v>7.3014712157319833E-2</c:v>
                  </c:pt>
                  <c:pt idx="9">
                    <c:v>7.1328258748443202E-2</c:v>
                  </c:pt>
                  <c:pt idx="10">
                    <c:v>8.8320503084570082E-2</c:v>
                  </c:pt>
                  <c:pt idx="11">
                    <c:v>2.9438048447093645E-2</c:v>
                  </c:pt>
                  <c:pt idx="12">
                    <c:v>5.9952414459304056E-2</c:v>
                  </c:pt>
                  <c:pt idx="13">
                    <c:v>8.8225604811423813E-3</c:v>
                  </c:pt>
                  <c:pt idx="14">
                    <c:v>9.0812550841732398E-2</c:v>
                  </c:pt>
                </c:numCache>
              </c:numRef>
            </c:minus>
          </c:errBars>
          <c:cat>
            <c:strRef>
              <c:f>'ADSC MBE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MBE'!$Q$166:$AE$166</c:f>
              <c:numCache>
                <c:formatCode>General</c:formatCode>
                <c:ptCount val="15"/>
                <c:pt idx="0">
                  <c:v>0.30474853718943679</c:v>
                </c:pt>
                <c:pt idx="1">
                  <c:v>0.132342431855</c:v>
                </c:pt>
                <c:pt idx="2">
                  <c:v>3.6623276670298042E-3</c:v>
                </c:pt>
                <c:pt idx="3">
                  <c:v>8.3271763418888936E-2</c:v>
                </c:pt>
                <c:pt idx="4">
                  <c:v>1.6989838008149514</c:v>
                </c:pt>
                <c:pt idx="5">
                  <c:v>2.9619634292763083E-2</c:v>
                </c:pt>
                <c:pt idx="6">
                  <c:v>8.7384796170402249E-2</c:v>
                </c:pt>
                <c:pt idx="7">
                  <c:v>1.3200332660824285</c:v>
                </c:pt>
                <c:pt idx="8">
                  <c:v>0.11660747796641313</c:v>
                </c:pt>
                <c:pt idx="9">
                  <c:v>0.13476307437157084</c:v>
                </c:pt>
                <c:pt idx="10">
                  <c:v>0.30241470626985095</c:v>
                </c:pt>
                <c:pt idx="11">
                  <c:v>8.7135357567272476E-2</c:v>
                </c:pt>
                <c:pt idx="12">
                  <c:v>0.11065095966399842</c:v>
                </c:pt>
                <c:pt idx="13">
                  <c:v>1.6261737036285223E-2</c:v>
                </c:pt>
                <c:pt idx="14">
                  <c:v>0.265579760899981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778368"/>
        <c:axId val="148784256"/>
      </c:barChart>
      <c:catAx>
        <c:axId val="148778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784256"/>
        <c:crosses val="autoZero"/>
        <c:auto val="1"/>
        <c:lblAlgn val="ctr"/>
        <c:lblOffset val="100"/>
        <c:noMultiLvlLbl val="0"/>
      </c:catAx>
      <c:valAx>
        <c:axId val="148784256"/>
        <c:scaling>
          <c:orientation val="minMax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7783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6748026715239831E-2"/>
          <c:y val="0.10879841996968909"/>
          <c:w val="0.93204675166970252"/>
          <c:h val="0.673802555399968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DSC FST'!$P$164</c:f>
              <c:strCache>
                <c:ptCount val="1"/>
                <c:pt idx="0">
                  <c:v>HMEC NORMA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FST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FST'!$Q$164:$AE$164</c:f>
              <c:numCache>
                <c:formatCode>General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FST'!$P$165</c:f>
              <c:strCache>
                <c:ptCount val="1"/>
                <c:pt idx="0">
                  <c:v>ADSC NORMA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Q$169:$AE$169</c:f>
                <c:numCache>
                  <c:formatCode>General</c:formatCode>
                  <c:ptCount val="15"/>
                  <c:pt idx="0">
                    <c:v>0.62828124481684144</c:v>
                  </c:pt>
                  <c:pt idx="1">
                    <c:v>3.3097583044583642E-3</c:v>
                  </c:pt>
                  <c:pt idx="2">
                    <c:v>5.4882142569587086E-3</c:v>
                  </c:pt>
                  <c:pt idx="3">
                    <c:v>1.5083932493176742E-3</c:v>
                  </c:pt>
                  <c:pt idx="4">
                    <c:v>0.89392491105595484</c:v>
                  </c:pt>
                  <c:pt idx="5">
                    <c:v>1.9779584641819004E-6</c:v>
                  </c:pt>
                  <c:pt idx="6">
                    <c:v>2.4785009309256818E-2</c:v>
                  </c:pt>
                  <c:pt idx="7">
                    <c:v>0.15408708760481091</c:v>
                  </c:pt>
                  <c:pt idx="8">
                    <c:v>9.7480526680463701E-3</c:v>
                  </c:pt>
                  <c:pt idx="9">
                    <c:v>0.15886541239713114</c:v>
                  </c:pt>
                  <c:pt idx="10">
                    <c:v>9.6513907074441928E-3</c:v>
                  </c:pt>
                  <c:pt idx="11">
                    <c:v>1.2443300699442876E-2</c:v>
                  </c:pt>
                  <c:pt idx="12">
                    <c:v>2.7378498498328721E-4</c:v>
                  </c:pt>
                  <c:pt idx="13">
                    <c:v>5.4596707437889044E-3</c:v>
                  </c:pt>
                  <c:pt idx="14">
                    <c:v>0.20662933153532165</c:v>
                  </c:pt>
                </c:numCache>
              </c:numRef>
            </c:plus>
            <c:minus>
              <c:numRef>
                <c:f>'ADSC FST'!$Q$169:$AE$169</c:f>
                <c:numCache>
                  <c:formatCode>General</c:formatCode>
                  <c:ptCount val="15"/>
                  <c:pt idx="0">
                    <c:v>0.62828124481684144</c:v>
                  </c:pt>
                  <c:pt idx="1">
                    <c:v>3.3097583044583642E-3</c:v>
                  </c:pt>
                  <c:pt idx="2">
                    <c:v>5.4882142569587086E-3</c:v>
                  </c:pt>
                  <c:pt idx="3">
                    <c:v>1.5083932493176742E-3</c:v>
                  </c:pt>
                  <c:pt idx="4">
                    <c:v>0.89392491105595484</c:v>
                  </c:pt>
                  <c:pt idx="5">
                    <c:v>1.9779584641819004E-6</c:v>
                  </c:pt>
                  <c:pt idx="6">
                    <c:v>2.4785009309256818E-2</c:v>
                  </c:pt>
                  <c:pt idx="7">
                    <c:v>0.15408708760481091</c:v>
                  </c:pt>
                  <c:pt idx="8">
                    <c:v>9.7480526680463701E-3</c:v>
                  </c:pt>
                  <c:pt idx="9">
                    <c:v>0.15886541239713114</c:v>
                  </c:pt>
                  <c:pt idx="10">
                    <c:v>9.6513907074441928E-3</c:v>
                  </c:pt>
                  <c:pt idx="11">
                    <c:v>1.2443300699442876E-2</c:v>
                  </c:pt>
                  <c:pt idx="12">
                    <c:v>2.7378498498328721E-4</c:v>
                  </c:pt>
                  <c:pt idx="13">
                    <c:v>5.4596707437889044E-3</c:v>
                  </c:pt>
                  <c:pt idx="14">
                    <c:v>0.20662933153532165</c:v>
                  </c:pt>
                </c:numCache>
              </c:numRef>
            </c:minus>
          </c:errBars>
          <c:cat>
            <c:strRef>
              <c:f>'ADSC FST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FST'!$Q$165:$AE$165</c:f>
              <c:numCache>
                <c:formatCode>General</c:formatCode>
                <c:ptCount val="15"/>
                <c:pt idx="0">
                  <c:v>2.4309231552916946</c:v>
                </c:pt>
                <c:pt idx="1">
                  <c:v>1.1454057227278708E-2</c:v>
                </c:pt>
                <c:pt idx="2">
                  <c:v>2.7806452291206301E-2</c:v>
                </c:pt>
                <c:pt idx="3">
                  <c:v>6.1124151998624698E-3</c:v>
                </c:pt>
                <c:pt idx="4">
                  <c:v>11.887617455743275</c:v>
                </c:pt>
                <c:pt idx="5">
                  <c:v>5.3475785526435006E-6</c:v>
                </c:pt>
                <c:pt idx="6">
                  <c:v>0.20217395242015032</c:v>
                </c:pt>
                <c:pt idx="7">
                  <c:v>1.2846257679899724</c:v>
                </c:pt>
                <c:pt idx="8">
                  <c:v>0.10694302378043437</c:v>
                </c:pt>
                <c:pt idx="9">
                  <c:v>2.4169969412156447</c:v>
                </c:pt>
                <c:pt idx="10">
                  <c:v>0.14159477444770965</c:v>
                </c:pt>
                <c:pt idx="11">
                  <c:v>2.8836923109723186E-2</c:v>
                </c:pt>
                <c:pt idx="12">
                  <c:v>8.0629841903701038E-4</c:v>
                </c:pt>
                <c:pt idx="13">
                  <c:v>3.1188366869764547E-2</c:v>
                </c:pt>
                <c:pt idx="14">
                  <c:v>0.56383821396881662</c:v>
                </c:pt>
              </c:numCache>
            </c:numRef>
          </c:val>
        </c:ser>
        <c:ser>
          <c:idx val="2"/>
          <c:order val="2"/>
          <c:tx>
            <c:strRef>
              <c:f>'ADSC FST'!$P$166</c:f>
              <c:strCache>
                <c:ptCount val="1"/>
                <c:pt idx="0">
                  <c:v>MES NORMA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Q$170:$AE$170</c:f>
                <c:numCache>
                  <c:formatCode>General</c:formatCode>
                  <c:ptCount val="15"/>
                  <c:pt idx="0">
                    <c:v>0.56617842906213678</c:v>
                  </c:pt>
                  <c:pt idx="1">
                    <c:v>5.801228059818523E-2</c:v>
                  </c:pt>
                  <c:pt idx="2">
                    <c:v>1.0855056923962037E-2</c:v>
                  </c:pt>
                  <c:pt idx="3">
                    <c:v>6.6024125242948109E-2</c:v>
                  </c:pt>
                  <c:pt idx="4">
                    <c:v>0.16174251226543557</c:v>
                  </c:pt>
                  <c:pt idx="5">
                    <c:v>2.8135964082761861E-3</c:v>
                  </c:pt>
                  <c:pt idx="6">
                    <c:v>2.597075933901867E-2</c:v>
                  </c:pt>
                  <c:pt idx="7">
                    <c:v>1.4999468770157678</c:v>
                  </c:pt>
                  <c:pt idx="8">
                    <c:v>3.004045781389666E-3</c:v>
                  </c:pt>
                  <c:pt idx="9">
                    <c:v>1.918565411395563E-2</c:v>
                  </c:pt>
                  <c:pt idx="10">
                    <c:v>0.24148972141310437</c:v>
                  </c:pt>
                  <c:pt idx="11">
                    <c:v>6.2713407240350977E-3</c:v>
                  </c:pt>
                  <c:pt idx="12">
                    <c:v>0.32305265295005164</c:v>
                  </c:pt>
                  <c:pt idx="13">
                    <c:v>2.3594506171505298E-3</c:v>
                  </c:pt>
                  <c:pt idx="14">
                    <c:v>8.9833124199144257E-2</c:v>
                  </c:pt>
                </c:numCache>
              </c:numRef>
            </c:plus>
            <c:minus>
              <c:numRef>
                <c:f>'ADSC FST'!$Q$170:$AE$170</c:f>
                <c:numCache>
                  <c:formatCode>General</c:formatCode>
                  <c:ptCount val="15"/>
                  <c:pt idx="0">
                    <c:v>0.56617842906213678</c:v>
                  </c:pt>
                  <c:pt idx="1">
                    <c:v>5.801228059818523E-2</c:v>
                  </c:pt>
                  <c:pt idx="2">
                    <c:v>1.0855056923962037E-2</c:v>
                  </c:pt>
                  <c:pt idx="3">
                    <c:v>6.6024125242948109E-2</c:v>
                  </c:pt>
                  <c:pt idx="4">
                    <c:v>0.16174251226543557</c:v>
                  </c:pt>
                  <c:pt idx="5">
                    <c:v>2.8135964082761861E-3</c:v>
                  </c:pt>
                  <c:pt idx="6">
                    <c:v>2.597075933901867E-2</c:v>
                  </c:pt>
                  <c:pt idx="7">
                    <c:v>1.4999468770157678</c:v>
                  </c:pt>
                  <c:pt idx="8">
                    <c:v>3.004045781389666E-3</c:v>
                  </c:pt>
                  <c:pt idx="9">
                    <c:v>1.918565411395563E-2</c:v>
                  </c:pt>
                  <c:pt idx="10">
                    <c:v>0.24148972141310437</c:v>
                  </c:pt>
                  <c:pt idx="11">
                    <c:v>6.2713407240350977E-3</c:v>
                  </c:pt>
                  <c:pt idx="12">
                    <c:v>0.32305265295005164</c:v>
                  </c:pt>
                  <c:pt idx="13">
                    <c:v>2.3594506171505298E-3</c:v>
                  </c:pt>
                  <c:pt idx="14">
                    <c:v>8.9833124199144257E-2</c:v>
                  </c:pt>
                </c:numCache>
              </c:numRef>
            </c:minus>
          </c:errBars>
          <c:cat>
            <c:strRef>
              <c:f>'ADSC FST'!$Q$163:$AE$163</c:f>
              <c:strCache>
                <c:ptCount val="15"/>
                <c:pt idx="0">
                  <c:v>MUC1</c:v>
                </c:pt>
                <c:pt idx="1">
                  <c:v>EPCAM</c:v>
                </c:pt>
                <c:pt idx="2">
                  <c:v>CDH1</c:v>
                </c:pt>
                <c:pt idx="3">
                  <c:v>CDH3</c:v>
                </c:pt>
                <c:pt idx="4">
                  <c:v>RAC1</c:v>
                </c:pt>
                <c:pt idx="5">
                  <c:v>KRT5</c:v>
                </c:pt>
                <c:pt idx="6">
                  <c:v>KRT7</c:v>
                </c:pt>
                <c:pt idx="7">
                  <c:v>KRT8</c:v>
                </c:pt>
                <c:pt idx="8">
                  <c:v>KRT14</c:v>
                </c:pt>
                <c:pt idx="9">
                  <c:v>KRT18</c:v>
                </c:pt>
                <c:pt idx="10">
                  <c:v>KRT19</c:v>
                </c:pt>
                <c:pt idx="11">
                  <c:v>MKI67</c:v>
                </c:pt>
                <c:pt idx="12">
                  <c:v>CD24</c:v>
                </c:pt>
                <c:pt idx="13">
                  <c:v>CD49f</c:v>
                </c:pt>
                <c:pt idx="14">
                  <c:v>ACTA1</c:v>
                </c:pt>
              </c:strCache>
            </c:strRef>
          </c:cat>
          <c:val>
            <c:numRef>
              <c:f>'ADSC FST'!$Q$166:$AE$166</c:f>
              <c:numCache>
                <c:formatCode>General</c:formatCode>
                <c:ptCount val="15"/>
                <c:pt idx="0">
                  <c:v>5.0051250297250709</c:v>
                </c:pt>
                <c:pt idx="1">
                  <c:v>0.33157065420235127</c:v>
                </c:pt>
                <c:pt idx="2">
                  <c:v>3.3313220463586625E-2</c:v>
                </c:pt>
                <c:pt idx="3">
                  <c:v>0.52566279120164827</c:v>
                </c:pt>
                <c:pt idx="4">
                  <c:v>1.2147390814828347</c:v>
                </c:pt>
                <c:pt idx="5">
                  <c:v>4.6353501367324773E-2</c:v>
                </c:pt>
                <c:pt idx="6">
                  <c:v>0.20096054532605465</c:v>
                </c:pt>
                <c:pt idx="7">
                  <c:v>8.1042244323737318</c:v>
                </c:pt>
                <c:pt idx="8">
                  <c:v>4.9113375462076191E-2</c:v>
                </c:pt>
                <c:pt idx="9">
                  <c:v>0.22959208894484728</c:v>
                </c:pt>
                <c:pt idx="10">
                  <c:v>1.3250927557112104</c:v>
                </c:pt>
                <c:pt idx="11">
                  <c:v>2.3023582067275297E-2</c:v>
                </c:pt>
                <c:pt idx="12">
                  <c:v>1.7266240393899821</c:v>
                </c:pt>
                <c:pt idx="13">
                  <c:v>1.5930108858077989E-2</c:v>
                </c:pt>
                <c:pt idx="14">
                  <c:v>0.256237871875241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827136"/>
        <c:axId val="148837120"/>
      </c:barChart>
      <c:catAx>
        <c:axId val="1488271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837120"/>
        <c:crosses val="autoZero"/>
        <c:auto val="1"/>
        <c:lblAlgn val="ctr"/>
        <c:lblOffset val="100"/>
        <c:noMultiLvlLbl val="0"/>
      </c:catAx>
      <c:valAx>
        <c:axId val="1488371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8271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SLA'!$AC$177</c:f>
              <c:strCache>
                <c:ptCount val="1"/>
                <c:pt idx="0">
                  <c:v>HMEC NORMA2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SLA'!$AD$176:$AF$176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SLA'!$AD$177:$AF$177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SLA'!$AC$178</c:f>
              <c:strCache>
                <c:ptCount val="1"/>
                <c:pt idx="0">
                  <c:v>ADSC NORMA2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AD$182:$AF$182</c:f>
                <c:numCache>
                  <c:formatCode>General</c:formatCode>
                  <c:ptCount val="3"/>
                  <c:pt idx="0">
                    <c:v>16.146393503264171</c:v>
                  </c:pt>
                  <c:pt idx="1">
                    <c:v>1.9924760820429319</c:v>
                  </c:pt>
                  <c:pt idx="2">
                    <c:v>15.905932627418744</c:v>
                  </c:pt>
                </c:numCache>
              </c:numRef>
            </c:plus>
            <c:minus>
              <c:numRef>
                <c:f>'ADSC SLA'!$AD$182:$AF$182</c:f>
                <c:numCache>
                  <c:formatCode>General</c:formatCode>
                  <c:ptCount val="3"/>
                  <c:pt idx="0">
                    <c:v>16.146393503264171</c:v>
                  </c:pt>
                  <c:pt idx="1">
                    <c:v>1.9924760820429319</c:v>
                  </c:pt>
                  <c:pt idx="2">
                    <c:v>15.905932627418744</c:v>
                  </c:pt>
                </c:numCache>
              </c:numRef>
            </c:minus>
          </c:errBars>
          <c:cat>
            <c:strRef>
              <c:f>'ADSC SLA'!$AD$176:$AF$176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SLA'!$AD$178:$AF$178</c:f>
              <c:numCache>
                <c:formatCode>General</c:formatCode>
                <c:ptCount val="3"/>
                <c:pt idx="0">
                  <c:v>111.79651998472097</c:v>
                </c:pt>
                <c:pt idx="1">
                  <c:v>6.2592691087243928</c:v>
                </c:pt>
                <c:pt idx="2">
                  <c:v>27.860856645264992</c:v>
                </c:pt>
              </c:numCache>
            </c:numRef>
          </c:val>
        </c:ser>
        <c:ser>
          <c:idx val="2"/>
          <c:order val="2"/>
          <c:tx>
            <c:strRef>
              <c:f>'ADSC SLA'!$AC$179</c:f>
              <c:strCache>
                <c:ptCount val="1"/>
                <c:pt idx="0">
                  <c:v>MES NORMA2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AD$183:$AF$183</c:f>
                <c:numCache>
                  <c:formatCode>General</c:formatCode>
                  <c:ptCount val="3"/>
                  <c:pt idx="0">
                    <c:v>23.213472675976423</c:v>
                  </c:pt>
                  <c:pt idx="1">
                    <c:v>0.42657450036519556</c:v>
                  </c:pt>
                  <c:pt idx="2">
                    <c:v>19.168898772577982</c:v>
                  </c:pt>
                </c:numCache>
              </c:numRef>
            </c:plus>
            <c:minus>
              <c:numRef>
                <c:f>'ADSC SLA'!$AD$183:$AF$183</c:f>
                <c:numCache>
                  <c:formatCode>General</c:formatCode>
                  <c:ptCount val="3"/>
                  <c:pt idx="0">
                    <c:v>23.213472675976423</c:v>
                  </c:pt>
                  <c:pt idx="1">
                    <c:v>0.42657450036519556</c:v>
                  </c:pt>
                  <c:pt idx="2">
                    <c:v>19.168898772577982</c:v>
                  </c:pt>
                </c:numCache>
              </c:numRef>
            </c:minus>
          </c:errBars>
          <c:cat>
            <c:strRef>
              <c:f>'ADSC SLA'!$AD$176:$AF$176</c:f>
              <c:strCache>
                <c:ptCount val="3"/>
                <c:pt idx="0">
                  <c:v>ACTA2</c:v>
                </c:pt>
                <c:pt idx="1">
                  <c:v>CNN1</c:v>
                </c:pt>
                <c:pt idx="2">
                  <c:v>CD10</c:v>
                </c:pt>
              </c:strCache>
            </c:strRef>
          </c:cat>
          <c:val>
            <c:numRef>
              <c:f>'ADSC SLA'!$AD$179:$AF$179</c:f>
              <c:numCache>
                <c:formatCode>General</c:formatCode>
                <c:ptCount val="3"/>
                <c:pt idx="0">
                  <c:v>80.440221908153191</c:v>
                </c:pt>
                <c:pt idx="1">
                  <c:v>2.592813430741415</c:v>
                </c:pt>
                <c:pt idx="2">
                  <c:v>204.909889122644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978304"/>
        <c:axId val="148988288"/>
      </c:barChart>
      <c:catAx>
        <c:axId val="1489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8988288"/>
        <c:crosses val="autoZero"/>
        <c:auto val="1"/>
        <c:lblAlgn val="ctr"/>
        <c:lblOffset val="100"/>
        <c:noMultiLvlLbl val="0"/>
      </c:catAx>
      <c:valAx>
        <c:axId val="14898828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89783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BD3008-0BE9-4A41-9510-3695C8385C78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60438" y="739775"/>
            <a:ext cx="4937125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689515"/>
            <a:ext cx="5486400" cy="444269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71800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377316"/>
            <a:ext cx="2971800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44BE97-5C19-44A2-85E8-B9DD929E20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48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0972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910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6211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5650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0658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1874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566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6484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3330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3893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5836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2528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6" name="Gruppieren 285"/>
          <p:cNvGrpSpPr/>
          <p:nvPr/>
        </p:nvGrpSpPr>
        <p:grpSpPr>
          <a:xfrm>
            <a:off x="107504" y="-20126"/>
            <a:ext cx="9073008" cy="6977518"/>
            <a:chOff x="107504" y="-20126"/>
            <a:chExt cx="9073008" cy="6977518"/>
          </a:xfrm>
        </p:grpSpPr>
        <p:graphicFrame>
          <p:nvGraphicFramePr>
            <p:cNvPr id="284" name="Diagramm 28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63333641"/>
                </p:ext>
              </p:extLst>
            </p:nvPr>
          </p:nvGraphicFramePr>
          <p:xfrm>
            <a:off x="7200678" y="-13525"/>
            <a:ext cx="1620000" cy="12938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Textfeld 1"/>
            <p:cNvSpPr txBox="1"/>
            <p:nvPr/>
          </p:nvSpPr>
          <p:spPr>
            <a:xfrm>
              <a:off x="7475168" y="6449561"/>
              <a:ext cx="1705344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endParaRPr lang="de-DE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C      ADSC      MES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" name="Diagramm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42378526"/>
                </p:ext>
              </p:extLst>
            </p:nvPr>
          </p:nvGraphicFramePr>
          <p:xfrm>
            <a:off x="576016" y="5225425"/>
            <a:ext cx="6580800" cy="14533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Diagramm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54809131"/>
                </p:ext>
              </p:extLst>
            </p:nvPr>
          </p:nvGraphicFramePr>
          <p:xfrm>
            <a:off x="7166325" y="5225425"/>
            <a:ext cx="1674000" cy="14533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Diagramm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1270819"/>
                </p:ext>
              </p:extLst>
            </p:nvPr>
          </p:nvGraphicFramePr>
          <p:xfrm>
            <a:off x="7524472" y="3857273"/>
            <a:ext cx="1296000" cy="13679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Diagramm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99464786"/>
                </p:ext>
              </p:extLst>
            </p:nvPr>
          </p:nvGraphicFramePr>
          <p:xfrm>
            <a:off x="576336" y="3857273"/>
            <a:ext cx="7020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Diagramm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88273172"/>
                </p:ext>
              </p:extLst>
            </p:nvPr>
          </p:nvGraphicFramePr>
          <p:xfrm>
            <a:off x="7128472" y="2561129"/>
            <a:ext cx="1692000" cy="136815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8" name="Diagramm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13552575"/>
                </p:ext>
              </p:extLst>
            </p:nvPr>
          </p:nvGraphicFramePr>
          <p:xfrm>
            <a:off x="539552" y="2525281"/>
            <a:ext cx="6624000" cy="140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9" name="Diagramm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9876713"/>
                </p:ext>
              </p:extLst>
            </p:nvPr>
          </p:nvGraphicFramePr>
          <p:xfrm>
            <a:off x="574525" y="-8009"/>
            <a:ext cx="6588000" cy="12840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0" name="Diagramm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19163711"/>
                </p:ext>
              </p:extLst>
            </p:nvPr>
          </p:nvGraphicFramePr>
          <p:xfrm>
            <a:off x="7128464" y="1276018"/>
            <a:ext cx="1620000" cy="12740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11" name="Diagramm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2063823"/>
                </p:ext>
              </p:extLst>
            </p:nvPr>
          </p:nvGraphicFramePr>
          <p:xfrm>
            <a:off x="630016" y="1218096"/>
            <a:ext cx="6516000" cy="133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12" name="Rechteck 11"/>
            <p:cNvSpPr/>
            <p:nvPr/>
          </p:nvSpPr>
          <p:spPr>
            <a:xfrm>
              <a:off x="7902592" y="6775658"/>
              <a:ext cx="84756" cy="79200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" name="Rechteck 12"/>
            <p:cNvSpPr/>
            <p:nvPr/>
          </p:nvSpPr>
          <p:spPr>
            <a:xfrm>
              <a:off x="7452320" y="6775658"/>
              <a:ext cx="84756" cy="792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4" name="Rechteck 13"/>
            <p:cNvSpPr/>
            <p:nvPr/>
          </p:nvSpPr>
          <p:spPr>
            <a:xfrm>
              <a:off x="8388424" y="6775658"/>
              <a:ext cx="84756" cy="79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395536" y="-20126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395536" y="1276018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395536" y="2500154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395536" y="3857273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395536" y="5236458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0" name="Textfeld 19"/>
            <p:cNvSpPr txBox="1"/>
            <p:nvPr/>
          </p:nvSpPr>
          <p:spPr>
            <a:xfrm rot="16200000">
              <a:off x="74803" y="586831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 rot="16200000">
              <a:off x="74597" y="1865341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 rot="16200000">
              <a:off x="74597" y="3098093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 rot="16200000">
              <a:off x="74597" y="4428270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 rot="16200000">
              <a:off x="74597" y="5825781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954222" y="588961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1043814" y="444945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27" name="Gruppieren 26"/>
            <p:cNvGrpSpPr/>
            <p:nvPr/>
          </p:nvGrpSpPr>
          <p:grpSpPr>
            <a:xfrm>
              <a:off x="1350222" y="804985"/>
              <a:ext cx="504672" cy="261610"/>
              <a:chOff x="737688" y="1404000"/>
              <a:chExt cx="504672" cy="261610"/>
            </a:xfrm>
          </p:grpSpPr>
          <p:sp>
            <p:nvSpPr>
              <p:cNvPr id="28" name="Textfeld 27"/>
              <p:cNvSpPr txBox="1"/>
              <p:nvPr/>
            </p:nvSpPr>
            <p:spPr>
              <a:xfrm>
                <a:off x="737688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9" name="Textfeld 28"/>
              <p:cNvSpPr txBox="1"/>
              <p:nvPr/>
            </p:nvSpPr>
            <p:spPr>
              <a:xfrm>
                <a:off x="846008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0" name="Gruppieren 29"/>
            <p:cNvGrpSpPr/>
            <p:nvPr/>
          </p:nvGrpSpPr>
          <p:grpSpPr>
            <a:xfrm>
              <a:off x="3420078" y="805851"/>
              <a:ext cx="485632" cy="261610"/>
              <a:chOff x="774000" y="1404000"/>
              <a:chExt cx="485632" cy="261610"/>
            </a:xfrm>
          </p:grpSpPr>
          <p:sp>
            <p:nvSpPr>
              <p:cNvPr id="31" name="Textfeld 30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3" name="Gruppieren 32"/>
            <p:cNvGrpSpPr/>
            <p:nvPr/>
          </p:nvGrpSpPr>
          <p:grpSpPr>
            <a:xfrm>
              <a:off x="4204290" y="804985"/>
              <a:ext cx="485632" cy="261610"/>
              <a:chOff x="774000" y="1404000"/>
              <a:chExt cx="485632" cy="261610"/>
            </a:xfrm>
          </p:grpSpPr>
          <p:sp>
            <p:nvSpPr>
              <p:cNvPr id="34" name="Textfeld 33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5" name="Textfeld 34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6" name="Gruppieren 35"/>
            <p:cNvGrpSpPr/>
            <p:nvPr/>
          </p:nvGrpSpPr>
          <p:grpSpPr>
            <a:xfrm>
              <a:off x="4644214" y="634547"/>
              <a:ext cx="485632" cy="432048"/>
              <a:chOff x="774000" y="1404000"/>
              <a:chExt cx="485632" cy="432048"/>
            </a:xfrm>
          </p:grpSpPr>
          <p:sp>
            <p:nvSpPr>
              <p:cNvPr id="37" name="Textfeld 36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863280" y="157443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9" name="Gruppieren 38"/>
            <p:cNvGrpSpPr/>
            <p:nvPr/>
          </p:nvGrpSpPr>
          <p:grpSpPr>
            <a:xfrm>
              <a:off x="5428426" y="804985"/>
              <a:ext cx="485632" cy="261610"/>
              <a:chOff x="774000" y="1404000"/>
              <a:chExt cx="485632" cy="261610"/>
            </a:xfrm>
          </p:grpSpPr>
          <p:sp>
            <p:nvSpPr>
              <p:cNvPr id="40" name="Textfeld 39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1" name="Textfeld 40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2" name="Gruppieren 41"/>
            <p:cNvGrpSpPr/>
            <p:nvPr/>
          </p:nvGrpSpPr>
          <p:grpSpPr>
            <a:xfrm>
              <a:off x="5868350" y="697851"/>
              <a:ext cx="486224" cy="368744"/>
              <a:chOff x="774000" y="1611320"/>
              <a:chExt cx="486224" cy="368744"/>
            </a:xfrm>
          </p:grpSpPr>
          <p:sp>
            <p:nvSpPr>
              <p:cNvPr id="43" name="Textfeld 42"/>
              <p:cNvSpPr txBox="1"/>
              <p:nvPr/>
            </p:nvSpPr>
            <p:spPr>
              <a:xfrm>
                <a:off x="774000" y="171845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4" name="Textfeld 43"/>
              <p:cNvSpPr txBox="1"/>
              <p:nvPr/>
            </p:nvSpPr>
            <p:spPr>
              <a:xfrm>
                <a:off x="863872" y="16113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5" name="Gruppieren 44"/>
            <p:cNvGrpSpPr/>
            <p:nvPr/>
          </p:nvGrpSpPr>
          <p:grpSpPr>
            <a:xfrm>
              <a:off x="6282222" y="804985"/>
              <a:ext cx="485632" cy="261610"/>
              <a:chOff x="774000" y="1404000"/>
              <a:chExt cx="485632" cy="261610"/>
            </a:xfrm>
          </p:grpSpPr>
          <p:sp>
            <p:nvSpPr>
              <p:cNvPr id="46" name="Textfeld 4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7" name="Textfeld 46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48" name="Textfeld 47"/>
            <p:cNvSpPr txBox="1"/>
            <p:nvPr/>
          </p:nvSpPr>
          <p:spPr>
            <a:xfrm>
              <a:off x="2591678" y="84905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2682222" y="697787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5039950" y="804985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1043608" y="204604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2591472" y="1397968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53" name="Gruppieren 52"/>
            <p:cNvGrpSpPr/>
            <p:nvPr/>
          </p:nvGrpSpPr>
          <p:grpSpPr>
            <a:xfrm>
              <a:off x="1377348" y="2072458"/>
              <a:ext cx="485632" cy="261610"/>
              <a:chOff x="774000" y="1404000"/>
              <a:chExt cx="485632" cy="261610"/>
            </a:xfrm>
          </p:grpSpPr>
          <p:sp>
            <p:nvSpPr>
              <p:cNvPr id="54" name="Textfeld 53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6" name="Gruppieren 55"/>
            <p:cNvGrpSpPr/>
            <p:nvPr/>
          </p:nvGrpSpPr>
          <p:grpSpPr>
            <a:xfrm>
              <a:off x="3411996" y="1974032"/>
              <a:ext cx="485632" cy="360040"/>
              <a:chOff x="774000" y="1404000"/>
              <a:chExt cx="485632" cy="360040"/>
            </a:xfrm>
          </p:grpSpPr>
          <p:sp>
            <p:nvSpPr>
              <p:cNvPr id="57" name="Textfeld 56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8" name="Textfeld 57"/>
              <p:cNvSpPr txBox="1"/>
              <p:nvPr/>
            </p:nvSpPr>
            <p:spPr>
              <a:xfrm>
                <a:off x="863280" y="150243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9" name="Gruppieren 58"/>
            <p:cNvGrpSpPr/>
            <p:nvPr/>
          </p:nvGrpSpPr>
          <p:grpSpPr>
            <a:xfrm>
              <a:off x="1809396" y="2072458"/>
              <a:ext cx="485632" cy="261610"/>
              <a:chOff x="774000" y="1404000"/>
              <a:chExt cx="485632" cy="261610"/>
            </a:xfrm>
          </p:grpSpPr>
          <p:sp>
            <p:nvSpPr>
              <p:cNvPr id="60" name="Textfeld 59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62" name="Gruppieren 61"/>
            <p:cNvGrpSpPr/>
            <p:nvPr/>
          </p:nvGrpSpPr>
          <p:grpSpPr>
            <a:xfrm>
              <a:off x="2187860" y="2072458"/>
              <a:ext cx="485632" cy="261610"/>
              <a:chOff x="774000" y="1404000"/>
              <a:chExt cx="485632" cy="261610"/>
            </a:xfrm>
          </p:grpSpPr>
          <p:sp>
            <p:nvSpPr>
              <p:cNvPr id="63" name="Textfeld 62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64" name="Textfeld 63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65" name="Gruppieren 64"/>
            <p:cNvGrpSpPr/>
            <p:nvPr/>
          </p:nvGrpSpPr>
          <p:grpSpPr>
            <a:xfrm>
              <a:off x="3844044" y="2072462"/>
              <a:ext cx="485632" cy="261610"/>
              <a:chOff x="774000" y="1404000"/>
              <a:chExt cx="485632" cy="261610"/>
            </a:xfrm>
          </p:grpSpPr>
          <p:sp>
            <p:nvSpPr>
              <p:cNvPr id="66" name="Textfeld 6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67" name="Textfeld 66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68" name="Gruppieren 67"/>
            <p:cNvGrpSpPr/>
            <p:nvPr/>
          </p:nvGrpSpPr>
          <p:grpSpPr>
            <a:xfrm>
              <a:off x="4626016" y="1397968"/>
              <a:ext cx="495748" cy="936104"/>
              <a:chOff x="782308" y="1521594"/>
              <a:chExt cx="495748" cy="936104"/>
            </a:xfrm>
          </p:grpSpPr>
          <p:sp>
            <p:nvSpPr>
              <p:cNvPr id="69" name="Textfeld 68"/>
              <p:cNvSpPr txBox="1"/>
              <p:nvPr/>
            </p:nvSpPr>
            <p:spPr>
              <a:xfrm>
                <a:off x="782308" y="152159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70" name="Textfeld 69"/>
              <p:cNvSpPr txBox="1"/>
              <p:nvPr/>
            </p:nvSpPr>
            <p:spPr>
              <a:xfrm>
                <a:off x="881704" y="219608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71" name="Textfeld 70"/>
            <p:cNvSpPr txBox="1"/>
            <p:nvPr/>
          </p:nvSpPr>
          <p:spPr>
            <a:xfrm>
              <a:off x="2682016" y="178443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72" name="Gruppieren 71"/>
            <p:cNvGrpSpPr/>
            <p:nvPr/>
          </p:nvGrpSpPr>
          <p:grpSpPr>
            <a:xfrm>
              <a:off x="954016" y="3236201"/>
              <a:ext cx="503216" cy="379204"/>
              <a:chOff x="756416" y="1404000"/>
              <a:chExt cx="503216" cy="379204"/>
            </a:xfrm>
          </p:grpSpPr>
          <p:sp>
            <p:nvSpPr>
              <p:cNvPr id="73" name="Textfeld 72"/>
              <p:cNvSpPr txBox="1"/>
              <p:nvPr/>
            </p:nvSpPr>
            <p:spPr>
              <a:xfrm>
                <a:off x="756416" y="152159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74" name="Textfeld 73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75" name="Gruppieren 74"/>
            <p:cNvGrpSpPr/>
            <p:nvPr/>
          </p:nvGrpSpPr>
          <p:grpSpPr>
            <a:xfrm>
              <a:off x="3006248" y="3425225"/>
              <a:ext cx="485632" cy="261610"/>
              <a:chOff x="774000" y="1404000"/>
              <a:chExt cx="485632" cy="261610"/>
            </a:xfrm>
          </p:grpSpPr>
          <p:sp>
            <p:nvSpPr>
              <p:cNvPr id="76" name="Textfeld 7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77" name="Textfeld 76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78" name="Textfeld 77"/>
            <p:cNvSpPr txBox="1"/>
            <p:nvPr/>
          </p:nvSpPr>
          <p:spPr>
            <a:xfrm>
              <a:off x="3815608" y="3380201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79" name="Gruppieren 78"/>
            <p:cNvGrpSpPr/>
            <p:nvPr/>
          </p:nvGrpSpPr>
          <p:grpSpPr>
            <a:xfrm>
              <a:off x="2610016" y="2561129"/>
              <a:ext cx="485632" cy="342650"/>
              <a:chOff x="774000" y="1404000"/>
              <a:chExt cx="485632" cy="342650"/>
            </a:xfrm>
          </p:grpSpPr>
          <p:sp>
            <p:nvSpPr>
              <p:cNvPr id="80" name="Textfeld 79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81" name="Textfeld 80"/>
              <p:cNvSpPr txBox="1"/>
              <p:nvPr/>
            </p:nvSpPr>
            <p:spPr>
              <a:xfrm>
                <a:off x="863280" y="148504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82" name="Gruppieren 81"/>
            <p:cNvGrpSpPr/>
            <p:nvPr/>
          </p:nvGrpSpPr>
          <p:grpSpPr>
            <a:xfrm>
              <a:off x="4221356" y="3353217"/>
              <a:ext cx="486056" cy="333618"/>
              <a:chOff x="773576" y="1404000"/>
              <a:chExt cx="486056" cy="333618"/>
            </a:xfrm>
          </p:grpSpPr>
          <p:sp>
            <p:nvSpPr>
              <p:cNvPr id="83" name="Textfeld 82"/>
              <p:cNvSpPr txBox="1"/>
              <p:nvPr/>
            </p:nvSpPr>
            <p:spPr>
              <a:xfrm>
                <a:off x="773576" y="14760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84" name="Textfeld 83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85" name="Textfeld 84"/>
            <p:cNvSpPr txBox="1"/>
            <p:nvPr/>
          </p:nvSpPr>
          <p:spPr>
            <a:xfrm>
              <a:off x="4751712" y="3353217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86" name="Gruppieren 85"/>
            <p:cNvGrpSpPr/>
            <p:nvPr/>
          </p:nvGrpSpPr>
          <p:grpSpPr>
            <a:xfrm>
              <a:off x="5472016" y="3281209"/>
              <a:ext cx="500752" cy="360040"/>
              <a:chOff x="784360" y="1476008"/>
              <a:chExt cx="500752" cy="360040"/>
            </a:xfrm>
          </p:grpSpPr>
          <p:sp>
            <p:nvSpPr>
              <p:cNvPr id="87" name="Textfeld 86"/>
              <p:cNvSpPr txBox="1"/>
              <p:nvPr/>
            </p:nvSpPr>
            <p:spPr>
              <a:xfrm>
                <a:off x="784360" y="14760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88" name="Textfeld 87"/>
              <p:cNvSpPr txBox="1"/>
              <p:nvPr/>
            </p:nvSpPr>
            <p:spPr>
              <a:xfrm>
                <a:off x="888760" y="157443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89" name="Gruppieren 88"/>
            <p:cNvGrpSpPr/>
            <p:nvPr/>
          </p:nvGrpSpPr>
          <p:grpSpPr>
            <a:xfrm>
              <a:off x="6696016" y="3065185"/>
              <a:ext cx="486496" cy="504056"/>
              <a:chOff x="774000" y="1367534"/>
              <a:chExt cx="486496" cy="504056"/>
            </a:xfrm>
          </p:grpSpPr>
          <p:sp>
            <p:nvSpPr>
              <p:cNvPr id="90" name="Textfeld 89"/>
              <p:cNvSpPr txBox="1"/>
              <p:nvPr/>
            </p:nvSpPr>
            <p:spPr>
              <a:xfrm>
                <a:off x="774000" y="136753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91" name="Textfeld 90"/>
              <p:cNvSpPr txBox="1"/>
              <p:nvPr/>
            </p:nvSpPr>
            <p:spPr>
              <a:xfrm>
                <a:off x="864144" y="16099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92" name="Gruppieren 91"/>
            <p:cNvGrpSpPr/>
            <p:nvPr/>
          </p:nvGrpSpPr>
          <p:grpSpPr>
            <a:xfrm>
              <a:off x="971600" y="4505345"/>
              <a:ext cx="482864" cy="432048"/>
              <a:chOff x="774000" y="1404000"/>
              <a:chExt cx="482864" cy="432048"/>
            </a:xfrm>
          </p:grpSpPr>
          <p:sp>
            <p:nvSpPr>
              <p:cNvPr id="93" name="Textfeld 92"/>
              <p:cNvSpPr txBox="1"/>
              <p:nvPr/>
            </p:nvSpPr>
            <p:spPr>
              <a:xfrm>
                <a:off x="774000" y="157443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94" name="Textfeld 93"/>
              <p:cNvSpPr txBox="1"/>
              <p:nvPr/>
            </p:nvSpPr>
            <p:spPr>
              <a:xfrm>
                <a:off x="860512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95" name="Gruppieren 94"/>
            <p:cNvGrpSpPr/>
            <p:nvPr/>
          </p:nvGrpSpPr>
          <p:grpSpPr>
            <a:xfrm>
              <a:off x="3438296" y="4675783"/>
              <a:ext cx="485632" cy="261610"/>
              <a:chOff x="774000" y="1404000"/>
              <a:chExt cx="485632" cy="261610"/>
            </a:xfrm>
          </p:grpSpPr>
          <p:sp>
            <p:nvSpPr>
              <p:cNvPr id="96" name="Textfeld 9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97" name="Textfeld 96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98" name="Gruppieren 97"/>
            <p:cNvGrpSpPr/>
            <p:nvPr/>
          </p:nvGrpSpPr>
          <p:grpSpPr>
            <a:xfrm>
              <a:off x="3851920" y="4577353"/>
              <a:ext cx="485632" cy="432048"/>
              <a:chOff x="774000" y="1404000"/>
              <a:chExt cx="485632" cy="432048"/>
            </a:xfrm>
          </p:grpSpPr>
          <p:sp>
            <p:nvSpPr>
              <p:cNvPr id="99" name="Textfeld 98"/>
              <p:cNvSpPr txBox="1"/>
              <p:nvPr/>
            </p:nvSpPr>
            <p:spPr>
              <a:xfrm>
                <a:off x="774000" y="157443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00" name="Textfeld 99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01" name="Gruppieren 100"/>
            <p:cNvGrpSpPr/>
            <p:nvPr/>
          </p:nvGrpSpPr>
          <p:grpSpPr>
            <a:xfrm>
              <a:off x="1386016" y="4721369"/>
              <a:ext cx="486624" cy="261610"/>
              <a:chOff x="774000" y="1404000"/>
              <a:chExt cx="486624" cy="261610"/>
            </a:xfrm>
          </p:grpSpPr>
          <p:sp>
            <p:nvSpPr>
              <p:cNvPr id="102" name="Textfeld 101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03" name="Textfeld 102"/>
              <p:cNvSpPr txBox="1"/>
              <p:nvPr/>
            </p:nvSpPr>
            <p:spPr>
              <a:xfrm>
                <a:off x="864272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04" name="Gruppieren 103"/>
            <p:cNvGrpSpPr/>
            <p:nvPr/>
          </p:nvGrpSpPr>
          <p:grpSpPr>
            <a:xfrm>
              <a:off x="5076056" y="4433337"/>
              <a:ext cx="485632" cy="549642"/>
              <a:chOff x="774000" y="1331992"/>
              <a:chExt cx="485632" cy="549642"/>
            </a:xfrm>
          </p:grpSpPr>
          <p:sp>
            <p:nvSpPr>
              <p:cNvPr id="105" name="Textfeld 104"/>
              <p:cNvSpPr txBox="1"/>
              <p:nvPr/>
            </p:nvSpPr>
            <p:spPr>
              <a:xfrm>
                <a:off x="774000" y="162002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06" name="Textfeld 105"/>
              <p:cNvSpPr txBox="1"/>
              <p:nvPr/>
            </p:nvSpPr>
            <p:spPr>
              <a:xfrm>
                <a:off x="863280" y="133199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07" name="Gruppieren 106"/>
            <p:cNvGrpSpPr/>
            <p:nvPr/>
          </p:nvGrpSpPr>
          <p:grpSpPr>
            <a:xfrm>
              <a:off x="5481804" y="4721369"/>
              <a:ext cx="485632" cy="261610"/>
              <a:chOff x="774000" y="1404000"/>
              <a:chExt cx="485632" cy="261610"/>
            </a:xfrm>
          </p:grpSpPr>
          <p:sp>
            <p:nvSpPr>
              <p:cNvPr id="108" name="Textfeld 107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09" name="Textfeld 108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110" name="Textfeld 109"/>
            <p:cNvSpPr txBox="1"/>
            <p:nvPr/>
          </p:nvSpPr>
          <p:spPr>
            <a:xfrm>
              <a:off x="1043608" y="5225425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111" name="Gruppieren 110"/>
            <p:cNvGrpSpPr/>
            <p:nvPr/>
          </p:nvGrpSpPr>
          <p:grpSpPr>
            <a:xfrm>
              <a:off x="3419872" y="6174741"/>
              <a:ext cx="485632" cy="288032"/>
              <a:chOff x="774000" y="1374383"/>
              <a:chExt cx="485632" cy="288032"/>
            </a:xfrm>
          </p:grpSpPr>
          <p:sp>
            <p:nvSpPr>
              <p:cNvPr id="112" name="Textfeld 111"/>
              <p:cNvSpPr txBox="1"/>
              <p:nvPr/>
            </p:nvSpPr>
            <p:spPr>
              <a:xfrm>
                <a:off x="774000" y="1374383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13" name="Textfeld 112"/>
              <p:cNvSpPr txBox="1"/>
              <p:nvPr/>
            </p:nvSpPr>
            <p:spPr>
              <a:xfrm>
                <a:off x="863280" y="1400805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14" name="Gruppieren 113"/>
            <p:cNvGrpSpPr/>
            <p:nvPr/>
          </p:nvGrpSpPr>
          <p:grpSpPr>
            <a:xfrm>
              <a:off x="3851920" y="6204358"/>
              <a:ext cx="485632" cy="261610"/>
              <a:chOff x="774000" y="1404000"/>
              <a:chExt cx="485632" cy="261610"/>
            </a:xfrm>
          </p:grpSpPr>
          <p:sp>
            <p:nvSpPr>
              <p:cNvPr id="115" name="Textfeld 114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16" name="Textfeld 115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17" name="Gruppieren 116"/>
            <p:cNvGrpSpPr/>
            <p:nvPr/>
          </p:nvGrpSpPr>
          <p:grpSpPr>
            <a:xfrm>
              <a:off x="4230384" y="6204358"/>
              <a:ext cx="485632" cy="261610"/>
              <a:chOff x="774000" y="1404000"/>
              <a:chExt cx="485632" cy="261610"/>
            </a:xfrm>
          </p:grpSpPr>
          <p:sp>
            <p:nvSpPr>
              <p:cNvPr id="118" name="Textfeld 117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19" name="Textfeld 118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20" name="Gruppieren 119"/>
            <p:cNvGrpSpPr/>
            <p:nvPr/>
          </p:nvGrpSpPr>
          <p:grpSpPr>
            <a:xfrm>
              <a:off x="5058016" y="5467871"/>
              <a:ext cx="486352" cy="883260"/>
              <a:chOff x="802800" y="1065683"/>
              <a:chExt cx="486352" cy="883260"/>
            </a:xfrm>
          </p:grpSpPr>
          <p:sp>
            <p:nvSpPr>
              <p:cNvPr id="121" name="Textfeld 120"/>
              <p:cNvSpPr txBox="1"/>
              <p:nvPr/>
            </p:nvSpPr>
            <p:spPr>
              <a:xfrm>
                <a:off x="802800" y="1687333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22" name="Textfeld 121"/>
              <p:cNvSpPr txBox="1"/>
              <p:nvPr/>
            </p:nvSpPr>
            <p:spPr>
              <a:xfrm>
                <a:off x="892800" y="1065683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123" name="Textfeld 122"/>
            <p:cNvSpPr txBox="1"/>
            <p:nvPr/>
          </p:nvSpPr>
          <p:spPr>
            <a:xfrm>
              <a:off x="4734016" y="6174741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24" name="Textfeld 123"/>
            <p:cNvSpPr txBox="1"/>
            <p:nvPr/>
          </p:nvSpPr>
          <p:spPr>
            <a:xfrm>
              <a:off x="5454016" y="6165341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25" name="Textfeld 124"/>
            <p:cNvSpPr txBox="1"/>
            <p:nvPr/>
          </p:nvSpPr>
          <p:spPr>
            <a:xfrm>
              <a:off x="6767936" y="5683895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26" name="Textfeld 125"/>
            <p:cNvSpPr txBox="1"/>
            <p:nvPr/>
          </p:nvSpPr>
          <p:spPr>
            <a:xfrm rot="16200000">
              <a:off x="-357438" y="522112"/>
              <a:ext cx="12241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feld 126"/>
            <p:cNvSpPr txBox="1"/>
            <p:nvPr/>
          </p:nvSpPr>
          <p:spPr>
            <a:xfrm rot="16200000">
              <a:off x="-383342" y="2790364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3</a:t>
              </a:r>
            </a:p>
          </p:txBody>
        </p:sp>
        <p:sp>
          <p:nvSpPr>
            <p:cNvPr id="128" name="Textfeld 127"/>
            <p:cNvSpPr txBox="1"/>
            <p:nvPr/>
          </p:nvSpPr>
          <p:spPr>
            <a:xfrm rot="16200000">
              <a:off x="-391712" y="4409612"/>
              <a:ext cx="13128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4</a:t>
              </a:r>
            </a:p>
          </p:txBody>
        </p:sp>
        <p:sp>
          <p:nvSpPr>
            <p:cNvPr id="129" name="Textfeld 128"/>
            <p:cNvSpPr txBox="1"/>
            <p:nvPr/>
          </p:nvSpPr>
          <p:spPr>
            <a:xfrm rot="16200000">
              <a:off x="-459971" y="5810080"/>
              <a:ext cx="14494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FDUC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feld 129"/>
            <p:cNvSpPr txBox="1"/>
            <p:nvPr/>
          </p:nvSpPr>
          <p:spPr>
            <a:xfrm rot="16200000">
              <a:off x="-341822" y="1751764"/>
              <a:ext cx="12131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2</a:t>
              </a:r>
            </a:p>
          </p:txBody>
        </p:sp>
        <p:grpSp>
          <p:nvGrpSpPr>
            <p:cNvPr id="131" name="Gruppieren 130"/>
            <p:cNvGrpSpPr/>
            <p:nvPr/>
          </p:nvGrpSpPr>
          <p:grpSpPr>
            <a:xfrm>
              <a:off x="7940128" y="3379639"/>
              <a:ext cx="520304" cy="261610"/>
              <a:chOff x="1321200" y="1097158"/>
              <a:chExt cx="515152" cy="261610"/>
            </a:xfrm>
          </p:grpSpPr>
          <p:sp>
            <p:nvSpPr>
              <p:cNvPr id="132" name="Textfeld 131"/>
              <p:cNvSpPr txBox="1"/>
              <p:nvPr/>
            </p:nvSpPr>
            <p:spPr>
              <a:xfrm>
                <a:off x="1321200" y="10971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33" name="Textfeld 132"/>
              <p:cNvSpPr txBox="1"/>
              <p:nvPr/>
            </p:nvSpPr>
            <p:spPr>
              <a:xfrm>
                <a:off x="1440000" y="10971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34" name="Gruppieren 133"/>
            <p:cNvGrpSpPr/>
            <p:nvPr/>
          </p:nvGrpSpPr>
          <p:grpSpPr>
            <a:xfrm>
              <a:off x="7560016" y="2587551"/>
              <a:ext cx="490316" cy="693658"/>
              <a:chOff x="1352618" y="835548"/>
              <a:chExt cx="485462" cy="693658"/>
            </a:xfrm>
          </p:grpSpPr>
          <p:sp>
            <p:nvSpPr>
              <p:cNvPr id="135" name="Textfeld 134"/>
              <p:cNvSpPr txBox="1"/>
              <p:nvPr/>
            </p:nvSpPr>
            <p:spPr>
              <a:xfrm>
                <a:off x="1352618" y="1267596"/>
                <a:ext cx="39635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36" name="Textfeld 135"/>
              <p:cNvSpPr txBox="1"/>
              <p:nvPr/>
            </p:nvSpPr>
            <p:spPr>
              <a:xfrm>
                <a:off x="1441727" y="835548"/>
                <a:ext cx="39635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37" name="Gruppieren 136"/>
            <p:cNvGrpSpPr/>
            <p:nvPr/>
          </p:nvGrpSpPr>
          <p:grpSpPr>
            <a:xfrm>
              <a:off x="7560016" y="1594828"/>
              <a:ext cx="488572" cy="352782"/>
              <a:chOff x="1321200" y="1097158"/>
              <a:chExt cx="483734" cy="352782"/>
            </a:xfrm>
          </p:grpSpPr>
          <p:sp>
            <p:nvSpPr>
              <p:cNvPr id="138" name="Textfeld 137"/>
              <p:cNvSpPr txBox="1"/>
              <p:nvPr/>
            </p:nvSpPr>
            <p:spPr>
              <a:xfrm>
                <a:off x="1321200" y="10971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39" name="Textfeld 138"/>
              <p:cNvSpPr txBox="1"/>
              <p:nvPr/>
            </p:nvSpPr>
            <p:spPr>
              <a:xfrm>
                <a:off x="1408582" y="118833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40" name="Gruppieren 139"/>
            <p:cNvGrpSpPr/>
            <p:nvPr/>
          </p:nvGrpSpPr>
          <p:grpSpPr>
            <a:xfrm>
              <a:off x="8298015" y="1336993"/>
              <a:ext cx="490724" cy="826641"/>
              <a:chOff x="1273813" y="1252207"/>
              <a:chExt cx="485865" cy="826641"/>
            </a:xfrm>
          </p:grpSpPr>
          <p:sp>
            <p:nvSpPr>
              <p:cNvPr id="141" name="Textfeld 140"/>
              <p:cNvSpPr txBox="1"/>
              <p:nvPr/>
            </p:nvSpPr>
            <p:spPr>
              <a:xfrm>
                <a:off x="1273813" y="181723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42" name="Textfeld 141"/>
              <p:cNvSpPr txBox="1"/>
              <p:nvPr/>
            </p:nvSpPr>
            <p:spPr>
              <a:xfrm>
                <a:off x="1363326" y="1252207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43" name="Gruppieren 142"/>
            <p:cNvGrpSpPr/>
            <p:nvPr/>
          </p:nvGrpSpPr>
          <p:grpSpPr>
            <a:xfrm>
              <a:off x="7570239" y="130491"/>
              <a:ext cx="490063" cy="720080"/>
              <a:chOff x="1321200" y="1241174"/>
              <a:chExt cx="485211" cy="720080"/>
            </a:xfrm>
          </p:grpSpPr>
          <p:sp>
            <p:nvSpPr>
              <p:cNvPr id="144" name="Textfeld 143"/>
              <p:cNvSpPr txBox="1"/>
              <p:nvPr/>
            </p:nvSpPr>
            <p:spPr>
              <a:xfrm>
                <a:off x="1321200" y="124117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45" name="Textfeld 144"/>
              <p:cNvSpPr txBox="1"/>
              <p:nvPr/>
            </p:nvSpPr>
            <p:spPr>
              <a:xfrm>
                <a:off x="1410059" y="16996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46" name="Gruppieren 145"/>
            <p:cNvGrpSpPr/>
            <p:nvPr/>
          </p:nvGrpSpPr>
          <p:grpSpPr>
            <a:xfrm>
              <a:off x="7602984" y="5395863"/>
              <a:ext cx="479384" cy="765666"/>
              <a:chOff x="1338944" y="1564050"/>
              <a:chExt cx="479384" cy="765666"/>
            </a:xfrm>
          </p:grpSpPr>
          <p:sp>
            <p:nvSpPr>
              <p:cNvPr id="147" name="Textfeld 146"/>
              <p:cNvSpPr txBox="1"/>
              <p:nvPr/>
            </p:nvSpPr>
            <p:spPr>
              <a:xfrm>
                <a:off x="1338944" y="206810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48" name="Textfeld 147"/>
              <p:cNvSpPr txBox="1"/>
              <p:nvPr/>
            </p:nvSpPr>
            <p:spPr>
              <a:xfrm>
                <a:off x="1421976" y="156405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49" name="Gruppieren 148"/>
            <p:cNvGrpSpPr/>
            <p:nvPr/>
          </p:nvGrpSpPr>
          <p:grpSpPr>
            <a:xfrm>
              <a:off x="8002816" y="6083569"/>
              <a:ext cx="479456" cy="307196"/>
              <a:chOff x="1321200" y="1492238"/>
              <a:chExt cx="479456" cy="307196"/>
            </a:xfrm>
          </p:grpSpPr>
          <p:sp>
            <p:nvSpPr>
              <p:cNvPr id="150" name="Textfeld 149"/>
              <p:cNvSpPr txBox="1"/>
              <p:nvPr/>
            </p:nvSpPr>
            <p:spPr>
              <a:xfrm>
                <a:off x="1321200" y="149223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51" name="Textfeld 150"/>
              <p:cNvSpPr txBox="1"/>
              <p:nvPr/>
            </p:nvSpPr>
            <p:spPr>
              <a:xfrm>
                <a:off x="1404304" y="153782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52" name="Gruppieren 151"/>
            <p:cNvGrpSpPr/>
            <p:nvPr/>
          </p:nvGrpSpPr>
          <p:grpSpPr>
            <a:xfrm>
              <a:off x="7965778" y="4433337"/>
              <a:ext cx="484600" cy="405626"/>
              <a:chOff x="1356550" y="1097158"/>
              <a:chExt cx="479802" cy="405626"/>
            </a:xfrm>
          </p:grpSpPr>
          <p:sp>
            <p:nvSpPr>
              <p:cNvPr id="153" name="Textfeld 152"/>
              <p:cNvSpPr txBox="1"/>
              <p:nvPr/>
            </p:nvSpPr>
            <p:spPr>
              <a:xfrm>
                <a:off x="1356550" y="124117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54" name="Textfeld 153"/>
              <p:cNvSpPr txBox="1"/>
              <p:nvPr/>
            </p:nvSpPr>
            <p:spPr>
              <a:xfrm>
                <a:off x="1440000" y="10971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55" name="Gruppieren 154"/>
            <p:cNvGrpSpPr/>
            <p:nvPr/>
          </p:nvGrpSpPr>
          <p:grpSpPr>
            <a:xfrm>
              <a:off x="8362122" y="3955703"/>
              <a:ext cx="480192" cy="981690"/>
              <a:chOff x="1350056" y="1051596"/>
              <a:chExt cx="475438" cy="981690"/>
            </a:xfrm>
          </p:grpSpPr>
          <p:sp>
            <p:nvSpPr>
              <p:cNvPr id="156" name="Textfeld 155"/>
              <p:cNvSpPr txBox="1"/>
              <p:nvPr/>
            </p:nvSpPr>
            <p:spPr>
              <a:xfrm>
                <a:off x="1350056" y="177167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57" name="Textfeld 156"/>
              <p:cNvSpPr txBox="1"/>
              <p:nvPr/>
            </p:nvSpPr>
            <p:spPr>
              <a:xfrm>
                <a:off x="1429142" y="105159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158" name="Rechteck 157"/>
            <p:cNvSpPr/>
            <p:nvPr/>
          </p:nvSpPr>
          <p:spPr>
            <a:xfrm>
              <a:off x="395536" y="40849"/>
              <a:ext cx="8382784" cy="122413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59" name="Rechteck 158"/>
            <p:cNvSpPr/>
            <p:nvPr/>
          </p:nvSpPr>
          <p:spPr>
            <a:xfrm>
              <a:off x="395536" y="1264985"/>
              <a:ext cx="8385212" cy="124895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Rechteck 159"/>
            <p:cNvSpPr/>
            <p:nvPr/>
          </p:nvSpPr>
          <p:spPr>
            <a:xfrm>
              <a:off x="395536" y="2513944"/>
              <a:ext cx="8385212" cy="136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1" name="Rechteck 160"/>
            <p:cNvSpPr/>
            <p:nvPr/>
          </p:nvSpPr>
          <p:spPr>
            <a:xfrm>
              <a:off x="395536" y="3883975"/>
              <a:ext cx="8385212" cy="133220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2" name="Rechteck 161"/>
            <p:cNvSpPr/>
            <p:nvPr/>
          </p:nvSpPr>
          <p:spPr>
            <a:xfrm>
              <a:off x="395536" y="5216185"/>
              <a:ext cx="8385212" cy="1449401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3" name="Rechteck 162"/>
            <p:cNvSpPr/>
            <p:nvPr/>
          </p:nvSpPr>
          <p:spPr>
            <a:xfrm>
              <a:off x="107504" y="40847"/>
              <a:ext cx="288032" cy="122413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4" name="Rechteck 163"/>
            <p:cNvSpPr/>
            <p:nvPr/>
          </p:nvSpPr>
          <p:spPr>
            <a:xfrm>
              <a:off x="107504" y="1264985"/>
              <a:ext cx="288032" cy="1250991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5" name="Rechteck 164"/>
            <p:cNvSpPr/>
            <p:nvPr/>
          </p:nvSpPr>
          <p:spPr>
            <a:xfrm>
              <a:off x="107504" y="2515976"/>
              <a:ext cx="288032" cy="136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6" name="Rechteck 165"/>
            <p:cNvSpPr/>
            <p:nvPr/>
          </p:nvSpPr>
          <p:spPr>
            <a:xfrm>
              <a:off x="107504" y="3883975"/>
              <a:ext cx="288032" cy="133220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7" name="Rechteck 166"/>
            <p:cNvSpPr/>
            <p:nvPr/>
          </p:nvSpPr>
          <p:spPr>
            <a:xfrm>
              <a:off x="107504" y="5216186"/>
              <a:ext cx="288032" cy="14494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8" name="Textfeld 167"/>
            <p:cNvSpPr txBox="1"/>
            <p:nvPr/>
          </p:nvSpPr>
          <p:spPr>
            <a:xfrm>
              <a:off x="4636816" y="5841123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169" name="Gruppieren 168"/>
            <p:cNvGrpSpPr/>
            <p:nvPr/>
          </p:nvGrpSpPr>
          <p:grpSpPr>
            <a:xfrm>
              <a:off x="2979948" y="2072462"/>
              <a:ext cx="485632" cy="261610"/>
              <a:chOff x="774000" y="1404000"/>
              <a:chExt cx="485632" cy="261610"/>
            </a:xfrm>
          </p:grpSpPr>
          <p:sp>
            <p:nvSpPr>
              <p:cNvPr id="170" name="Textfeld 169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71" name="Textfeld 170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72" name="Gruppieren 171"/>
            <p:cNvGrpSpPr/>
            <p:nvPr/>
          </p:nvGrpSpPr>
          <p:grpSpPr>
            <a:xfrm>
              <a:off x="4257668" y="2072462"/>
              <a:ext cx="485632" cy="261610"/>
              <a:chOff x="774000" y="1404000"/>
              <a:chExt cx="485632" cy="261610"/>
            </a:xfrm>
          </p:grpSpPr>
          <p:sp>
            <p:nvSpPr>
              <p:cNvPr id="173" name="Textfeld 172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74" name="Textfeld 173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75" name="Gruppieren 174"/>
            <p:cNvGrpSpPr/>
            <p:nvPr/>
          </p:nvGrpSpPr>
          <p:grpSpPr>
            <a:xfrm>
              <a:off x="5068180" y="2072462"/>
              <a:ext cx="485632" cy="261610"/>
              <a:chOff x="774000" y="1404000"/>
              <a:chExt cx="485632" cy="261610"/>
            </a:xfrm>
          </p:grpSpPr>
          <p:sp>
            <p:nvSpPr>
              <p:cNvPr id="176" name="Textfeld 17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77" name="Textfeld 176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78" name="Gruppieren 177"/>
            <p:cNvGrpSpPr/>
            <p:nvPr/>
          </p:nvGrpSpPr>
          <p:grpSpPr>
            <a:xfrm>
              <a:off x="5445780" y="2000454"/>
              <a:ext cx="504384" cy="333618"/>
              <a:chOff x="737976" y="1404000"/>
              <a:chExt cx="504384" cy="333618"/>
            </a:xfrm>
          </p:grpSpPr>
          <p:sp>
            <p:nvSpPr>
              <p:cNvPr id="179" name="Textfeld 178"/>
              <p:cNvSpPr txBox="1"/>
              <p:nvPr/>
            </p:nvSpPr>
            <p:spPr>
              <a:xfrm>
                <a:off x="737976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80" name="Textfeld 179"/>
              <p:cNvSpPr txBox="1"/>
              <p:nvPr/>
            </p:nvSpPr>
            <p:spPr>
              <a:xfrm>
                <a:off x="846008" y="14760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81" name="Gruppieren 180"/>
            <p:cNvGrpSpPr/>
            <p:nvPr/>
          </p:nvGrpSpPr>
          <p:grpSpPr>
            <a:xfrm>
              <a:off x="5860268" y="2072462"/>
              <a:ext cx="485632" cy="261610"/>
              <a:chOff x="774000" y="1404000"/>
              <a:chExt cx="485632" cy="261610"/>
            </a:xfrm>
          </p:grpSpPr>
          <p:sp>
            <p:nvSpPr>
              <p:cNvPr id="182" name="Textfeld 181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83" name="Textfeld 182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84" name="Gruppieren 183"/>
            <p:cNvGrpSpPr/>
            <p:nvPr/>
          </p:nvGrpSpPr>
          <p:grpSpPr>
            <a:xfrm>
              <a:off x="6273892" y="2072462"/>
              <a:ext cx="485632" cy="261610"/>
              <a:chOff x="774000" y="1404000"/>
              <a:chExt cx="485632" cy="261610"/>
            </a:xfrm>
          </p:grpSpPr>
          <p:sp>
            <p:nvSpPr>
              <p:cNvPr id="185" name="Textfeld 184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86" name="Textfeld 185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87" name="Gruppieren 186"/>
            <p:cNvGrpSpPr/>
            <p:nvPr/>
          </p:nvGrpSpPr>
          <p:grpSpPr>
            <a:xfrm>
              <a:off x="6669780" y="1758008"/>
              <a:ext cx="503792" cy="504056"/>
              <a:chOff x="755840" y="1476008"/>
              <a:chExt cx="503792" cy="504056"/>
            </a:xfrm>
          </p:grpSpPr>
          <p:sp>
            <p:nvSpPr>
              <p:cNvPr id="188" name="Textfeld 187"/>
              <p:cNvSpPr txBox="1"/>
              <p:nvPr/>
            </p:nvSpPr>
            <p:spPr>
              <a:xfrm>
                <a:off x="755840" y="14760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89" name="Textfeld 188"/>
              <p:cNvSpPr txBox="1"/>
              <p:nvPr/>
            </p:nvSpPr>
            <p:spPr>
              <a:xfrm>
                <a:off x="863280" y="171845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90" name="Gruppieren 189"/>
            <p:cNvGrpSpPr/>
            <p:nvPr/>
          </p:nvGrpSpPr>
          <p:grpSpPr>
            <a:xfrm>
              <a:off x="7940128" y="2046040"/>
              <a:ext cx="520304" cy="261610"/>
              <a:chOff x="1321200" y="1097158"/>
              <a:chExt cx="515152" cy="261610"/>
            </a:xfrm>
          </p:grpSpPr>
          <p:sp>
            <p:nvSpPr>
              <p:cNvPr id="191" name="Textfeld 190"/>
              <p:cNvSpPr txBox="1"/>
              <p:nvPr/>
            </p:nvSpPr>
            <p:spPr>
              <a:xfrm>
                <a:off x="1321200" y="10971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92" name="Textfeld 191"/>
              <p:cNvSpPr txBox="1"/>
              <p:nvPr/>
            </p:nvSpPr>
            <p:spPr>
              <a:xfrm>
                <a:off x="1440000" y="10971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93" name="Gruppieren 192"/>
            <p:cNvGrpSpPr/>
            <p:nvPr/>
          </p:nvGrpSpPr>
          <p:grpSpPr>
            <a:xfrm>
              <a:off x="1782222" y="804985"/>
              <a:ext cx="504672" cy="261610"/>
              <a:chOff x="737688" y="1404000"/>
              <a:chExt cx="504672" cy="261610"/>
            </a:xfrm>
          </p:grpSpPr>
          <p:sp>
            <p:nvSpPr>
              <p:cNvPr id="194" name="Textfeld 193"/>
              <p:cNvSpPr txBox="1"/>
              <p:nvPr/>
            </p:nvSpPr>
            <p:spPr>
              <a:xfrm>
                <a:off x="737688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95" name="Textfeld 194"/>
              <p:cNvSpPr txBox="1"/>
              <p:nvPr/>
            </p:nvSpPr>
            <p:spPr>
              <a:xfrm>
                <a:off x="846008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96" name="Gruppieren 195"/>
            <p:cNvGrpSpPr/>
            <p:nvPr/>
          </p:nvGrpSpPr>
          <p:grpSpPr>
            <a:xfrm>
              <a:off x="2169026" y="778563"/>
              <a:ext cx="504672" cy="261610"/>
              <a:chOff x="737688" y="1404000"/>
              <a:chExt cx="504672" cy="261610"/>
            </a:xfrm>
          </p:grpSpPr>
          <p:sp>
            <p:nvSpPr>
              <p:cNvPr id="197" name="Textfeld 196"/>
              <p:cNvSpPr txBox="1"/>
              <p:nvPr/>
            </p:nvSpPr>
            <p:spPr>
              <a:xfrm>
                <a:off x="737688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98" name="Textfeld 197"/>
              <p:cNvSpPr txBox="1"/>
              <p:nvPr/>
            </p:nvSpPr>
            <p:spPr>
              <a:xfrm>
                <a:off x="846008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99" name="Gruppieren 198"/>
            <p:cNvGrpSpPr/>
            <p:nvPr/>
          </p:nvGrpSpPr>
          <p:grpSpPr>
            <a:xfrm>
              <a:off x="2997986" y="804985"/>
              <a:ext cx="485632" cy="261610"/>
              <a:chOff x="774000" y="1404000"/>
              <a:chExt cx="485632" cy="261610"/>
            </a:xfrm>
          </p:grpSpPr>
          <p:sp>
            <p:nvSpPr>
              <p:cNvPr id="200" name="Textfeld 199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01" name="Textfeld 200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02" name="Gruppieren 201"/>
            <p:cNvGrpSpPr/>
            <p:nvPr/>
          </p:nvGrpSpPr>
          <p:grpSpPr>
            <a:xfrm>
              <a:off x="3815814" y="228921"/>
              <a:ext cx="497560" cy="765666"/>
              <a:chOff x="791272" y="1475062"/>
              <a:chExt cx="497560" cy="765666"/>
            </a:xfrm>
          </p:grpSpPr>
          <p:sp>
            <p:nvSpPr>
              <p:cNvPr id="203" name="Textfeld 202"/>
              <p:cNvSpPr txBox="1"/>
              <p:nvPr/>
            </p:nvSpPr>
            <p:spPr>
              <a:xfrm>
                <a:off x="791272" y="197911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04" name="Textfeld 203"/>
              <p:cNvSpPr txBox="1"/>
              <p:nvPr/>
            </p:nvSpPr>
            <p:spPr>
              <a:xfrm>
                <a:off x="892480" y="147506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05" name="Gruppieren 204"/>
            <p:cNvGrpSpPr/>
            <p:nvPr/>
          </p:nvGrpSpPr>
          <p:grpSpPr>
            <a:xfrm>
              <a:off x="6696222" y="732977"/>
              <a:ext cx="485632" cy="333618"/>
              <a:chOff x="774000" y="1404000"/>
              <a:chExt cx="485632" cy="333618"/>
            </a:xfrm>
          </p:grpSpPr>
          <p:sp>
            <p:nvSpPr>
              <p:cNvPr id="206" name="Textfeld 20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07" name="Textfeld 206"/>
              <p:cNvSpPr txBox="1"/>
              <p:nvPr/>
            </p:nvSpPr>
            <p:spPr>
              <a:xfrm>
                <a:off x="863280" y="14760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08" name="Gruppieren 207"/>
            <p:cNvGrpSpPr/>
            <p:nvPr/>
          </p:nvGrpSpPr>
          <p:grpSpPr>
            <a:xfrm>
              <a:off x="7965986" y="660969"/>
              <a:ext cx="485632" cy="405626"/>
              <a:chOff x="774000" y="1404000"/>
              <a:chExt cx="485632" cy="405626"/>
            </a:xfrm>
          </p:grpSpPr>
          <p:sp>
            <p:nvSpPr>
              <p:cNvPr id="209" name="Textfeld 208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10" name="Textfeld 209"/>
              <p:cNvSpPr txBox="1"/>
              <p:nvPr/>
            </p:nvSpPr>
            <p:spPr>
              <a:xfrm>
                <a:off x="863280" y="154801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11" name="Gruppieren 210"/>
            <p:cNvGrpSpPr/>
            <p:nvPr/>
          </p:nvGrpSpPr>
          <p:grpSpPr>
            <a:xfrm>
              <a:off x="8347586" y="706555"/>
              <a:ext cx="485632" cy="333618"/>
              <a:chOff x="774000" y="1404000"/>
              <a:chExt cx="485632" cy="333618"/>
            </a:xfrm>
          </p:grpSpPr>
          <p:sp>
            <p:nvSpPr>
              <p:cNvPr id="212" name="Textfeld 211"/>
              <p:cNvSpPr txBox="1"/>
              <p:nvPr/>
            </p:nvSpPr>
            <p:spPr>
              <a:xfrm>
                <a:off x="774000" y="14760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13" name="Textfeld 212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14" name="Gruppieren 213"/>
            <p:cNvGrpSpPr/>
            <p:nvPr/>
          </p:nvGrpSpPr>
          <p:grpSpPr>
            <a:xfrm>
              <a:off x="1368016" y="3353217"/>
              <a:ext cx="485632" cy="324594"/>
              <a:chOff x="774000" y="1404000"/>
              <a:chExt cx="485632" cy="324594"/>
            </a:xfrm>
          </p:grpSpPr>
          <p:sp>
            <p:nvSpPr>
              <p:cNvPr id="215" name="Textfeld 214"/>
              <p:cNvSpPr txBox="1"/>
              <p:nvPr/>
            </p:nvSpPr>
            <p:spPr>
              <a:xfrm>
                <a:off x="774000" y="146698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16" name="Textfeld 215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17" name="Gruppieren 216"/>
            <p:cNvGrpSpPr/>
            <p:nvPr/>
          </p:nvGrpSpPr>
          <p:grpSpPr>
            <a:xfrm>
              <a:off x="1782112" y="3425225"/>
              <a:ext cx="485632" cy="261610"/>
              <a:chOff x="774000" y="1404000"/>
              <a:chExt cx="485632" cy="261610"/>
            </a:xfrm>
          </p:grpSpPr>
          <p:sp>
            <p:nvSpPr>
              <p:cNvPr id="218" name="Textfeld 217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19" name="Textfeld 218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20" name="Gruppieren 219"/>
            <p:cNvGrpSpPr/>
            <p:nvPr/>
          </p:nvGrpSpPr>
          <p:grpSpPr>
            <a:xfrm>
              <a:off x="2195736" y="3353217"/>
              <a:ext cx="485632" cy="333618"/>
              <a:chOff x="774000" y="1404000"/>
              <a:chExt cx="485632" cy="333618"/>
            </a:xfrm>
          </p:grpSpPr>
          <p:sp>
            <p:nvSpPr>
              <p:cNvPr id="221" name="Textfeld 220"/>
              <p:cNvSpPr txBox="1"/>
              <p:nvPr/>
            </p:nvSpPr>
            <p:spPr>
              <a:xfrm>
                <a:off x="774000" y="14760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22" name="Textfeld 221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23" name="Gruppieren 222"/>
            <p:cNvGrpSpPr/>
            <p:nvPr/>
          </p:nvGrpSpPr>
          <p:grpSpPr>
            <a:xfrm>
              <a:off x="3411996" y="3353217"/>
              <a:ext cx="485632" cy="288032"/>
              <a:chOff x="774000" y="1404000"/>
              <a:chExt cx="485632" cy="288032"/>
            </a:xfrm>
          </p:grpSpPr>
          <p:sp>
            <p:nvSpPr>
              <p:cNvPr id="224" name="Textfeld 223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25" name="Textfeld 224"/>
              <p:cNvSpPr txBox="1"/>
              <p:nvPr/>
            </p:nvSpPr>
            <p:spPr>
              <a:xfrm>
                <a:off x="863280" y="14304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26" name="Gruppieren 225"/>
            <p:cNvGrpSpPr/>
            <p:nvPr/>
          </p:nvGrpSpPr>
          <p:grpSpPr>
            <a:xfrm>
              <a:off x="5058016" y="3137193"/>
              <a:ext cx="493552" cy="405626"/>
              <a:chOff x="774000" y="1404000"/>
              <a:chExt cx="493552" cy="405626"/>
            </a:xfrm>
          </p:grpSpPr>
          <p:sp>
            <p:nvSpPr>
              <p:cNvPr id="227" name="Textfeld 226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28" name="Textfeld 227"/>
              <p:cNvSpPr txBox="1"/>
              <p:nvPr/>
            </p:nvSpPr>
            <p:spPr>
              <a:xfrm>
                <a:off x="871200" y="154801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29" name="Gruppieren 228"/>
            <p:cNvGrpSpPr/>
            <p:nvPr/>
          </p:nvGrpSpPr>
          <p:grpSpPr>
            <a:xfrm>
              <a:off x="5878816" y="3353217"/>
              <a:ext cx="486056" cy="333618"/>
              <a:chOff x="773576" y="1404000"/>
              <a:chExt cx="486056" cy="333618"/>
            </a:xfrm>
          </p:grpSpPr>
          <p:sp>
            <p:nvSpPr>
              <p:cNvPr id="230" name="Textfeld 229"/>
              <p:cNvSpPr txBox="1"/>
              <p:nvPr/>
            </p:nvSpPr>
            <p:spPr>
              <a:xfrm>
                <a:off x="773576" y="14760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31" name="Textfeld 230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32" name="Gruppieren 231"/>
            <p:cNvGrpSpPr/>
            <p:nvPr/>
          </p:nvGrpSpPr>
          <p:grpSpPr>
            <a:xfrm>
              <a:off x="6273892" y="3425225"/>
              <a:ext cx="485632" cy="261610"/>
              <a:chOff x="774000" y="1404000"/>
              <a:chExt cx="485632" cy="261610"/>
            </a:xfrm>
          </p:grpSpPr>
          <p:sp>
            <p:nvSpPr>
              <p:cNvPr id="233" name="Textfeld 232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34" name="Textfeld 233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235" name="Textfeld 234"/>
            <p:cNvSpPr txBox="1"/>
            <p:nvPr/>
          </p:nvSpPr>
          <p:spPr>
            <a:xfrm>
              <a:off x="8444580" y="3281209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236" name="Gruppieren 235"/>
            <p:cNvGrpSpPr/>
            <p:nvPr/>
          </p:nvGrpSpPr>
          <p:grpSpPr>
            <a:xfrm>
              <a:off x="1781120" y="4721369"/>
              <a:ext cx="486624" cy="261610"/>
              <a:chOff x="774000" y="1404000"/>
              <a:chExt cx="486624" cy="261610"/>
            </a:xfrm>
          </p:grpSpPr>
          <p:sp>
            <p:nvSpPr>
              <p:cNvPr id="237" name="Textfeld 236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38" name="Textfeld 237"/>
              <p:cNvSpPr txBox="1"/>
              <p:nvPr/>
            </p:nvSpPr>
            <p:spPr>
              <a:xfrm>
                <a:off x="864272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39" name="Gruppieren 238"/>
            <p:cNvGrpSpPr/>
            <p:nvPr/>
          </p:nvGrpSpPr>
          <p:grpSpPr>
            <a:xfrm>
              <a:off x="2195736" y="4577353"/>
              <a:ext cx="482864" cy="432048"/>
              <a:chOff x="774000" y="1404000"/>
              <a:chExt cx="482864" cy="432048"/>
            </a:xfrm>
          </p:grpSpPr>
          <p:sp>
            <p:nvSpPr>
              <p:cNvPr id="240" name="Textfeld 239"/>
              <p:cNvSpPr txBox="1"/>
              <p:nvPr/>
            </p:nvSpPr>
            <p:spPr>
              <a:xfrm>
                <a:off x="774000" y="157443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41" name="Textfeld 240"/>
              <p:cNvSpPr txBox="1"/>
              <p:nvPr/>
            </p:nvSpPr>
            <p:spPr>
              <a:xfrm>
                <a:off x="860512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42" name="Gruppieren 241"/>
            <p:cNvGrpSpPr/>
            <p:nvPr/>
          </p:nvGrpSpPr>
          <p:grpSpPr>
            <a:xfrm>
              <a:off x="2610016" y="4145305"/>
              <a:ext cx="486624" cy="405626"/>
              <a:chOff x="774000" y="1404000"/>
              <a:chExt cx="486624" cy="405626"/>
            </a:xfrm>
          </p:grpSpPr>
          <p:sp>
            <p:nvSpPr>
              <p:cNvPr id="243" name="Textfeld 242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44" name="Textfeld 243"/>
              <p:cNvSpPr txBox="1"/>
              <p:nvPr/>
            </p:nvSpPr>
            <p:spPr>
              <a:xfrm>
                <a:off x="864272" y="154801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45" name="Gruppieren 244"/>
            <p:cNvGrpSpPr/>
            <p:nvPr/>
          </p:nvGrpSpPr>
          <p:grpSpPr>
            <a:xfrm>
              <a:off x="3005256" y="4721369"/>
              <a:ext cx="486624" cy="261610"/>
              <a:chOff x="774000" y="1404000"/>
              <a:chExt cx="486624" cy="261610"/>
            </a:xfrm>
          </p:grpSpPr>
          <p:sp>
            <p:nvSpPr>
              <p:cNvPr id="246" name="Textfeld 24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47" name="Textfeld 246"/>
              <p:cNvSpPr txBox="1"/>
              <p:nvPr/>
            </p:nvSpPr>
            <p:spPr>
              <a:xfrm>
                <a:off x="864272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48" name="Gruppieren 247"/>
            <p:cNvGrpSpPr/>
            <p:nvPr/>
          </p:nvGrpSpPr>
          <p:grpSpPr>
            <a:xfrm>
              <a:off x="4230384" y="4721369"/>
              <a:ext cx="485632" cy="261610"/>
              <a:chOff x="774000" y="1404000"/>
              <a:chExt cx="485632" cy="261610"/>
            </a:xfrm>
          </p:grpSpPr>
          <p:sp>
            <p:nvSpPr>
              <p:cNvPr id="249" name="Textfeld 248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50" name="Textfeld 249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51" name="Gruppieren 250"/>
            <p:cNvGrpSpPr/>
            <p:nvPr/>
          </p:nvGrpSpPr>
          <p:grpSpPr>
            <a:xfrm>
              <a:off x="4662432" y="4721369"/>
              <a:ext cx="485632" cy="261610"/>
              <a:chOff x="774000" y="1404000"/>
              <a:chExt cx="485632" cy="261610"/>
            </a:xfrm>
          </p:grpSpPr>
          <p:sp>
            <p:nvSpPr>
              <p:cNvPr id="252" name="Textfeld 251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53" name="Textfeld 252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254" name="Textfeld 253"/>
            <p:cNvSpPr txBox="1"/>
            <p:nvPr/>
          </p:nvSpPr>
          <p:spPr>
            <a:xfrm>
              <a:off x="5886016" y="4721369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255" name="Gruppieren 254"/>
            <p:cNvGrpSpPr/>
            <p:nvPr/>
          </p:nvGrpSpPr>
          <p:grpSpPr>
            <a:xfrm>
              <a:off x="6292316" y="4721369"/>
              <a:ext cx="485632" cy="261610"/>
              <a:chOff x="774000" y="1404000"/>
              <a:chExt cx="485632" cy="261610"/>
            </a:xfrm>
          </p:grpSpPr>
          <p:sp>
            <p:nvSpPr>
              <p:cNvPr id="256" name="Textfeld 25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57" name="Textfeld 256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58" name="Gruppieren 257"/>
            <p:cNvGrpSpPr/>
            <p:nvPr/>
          </p:nvGrpSpPr>
          <p:grpSpPr>
            <a:xfrm>
              <a:off x="6714016" y="3929281"/>
              <a:ext cx="486352" cy="621650"/>
              <a:chOff x="755776" y="1305096"/>
              <a:chExt cx="486352" cy="621650"/>
            </a:xfrm>
          </p:grpSpPr>
          <p:sp>
            <p:nvSpPr>
              <p:cNvPr id="259" name="Textfeld 258"/>
              <p:cNvSpPr txBox="1"/>
              <p:nvPr/>
            </p:nvSpPr>
            <p:spPr>
              <a:xfrm>
                <a:off x="755776" y="166513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60" name="Textfeld 259"/>
              <p:cNvSpPr txBox="1"/>
              <p:nvPr/>
            </p:nvSpPr>
            <p:spPr>
              <a:xfrm>
                <a:off x="845776" y="130509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61" name="Gruppieren 260"/>
            <p:cNvGrpSpPr/>
            <p:nvPr/>
          </p:nvGrpSpPr>
          <p:grpSpPr>
            <a:xfrm>
              <a:off x="7128016" y="4378893"/>
              <a:ext cx="485632" cy="342476"/>
              <a:chOff x="774000" y="1539158"/>
              <a:chExt cx="485632" cy="342476"/>
            </a:xfrm>
          </p:grpSpPr>
          <p:sp>
            <p:nvSpPr>
              <p:cNvPr id="262" name="Textfeld 261"/>
              <p:cNvSpPr txBox="1"/>
              <p:nvPr/>
            </p:nvSpPr>
            <p:spPr>
              <a:xfrm>
                <a:off x="774000" y="162002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63" name="Textfeld 262"/>
              <p:cNvSpPr txBox="1"/>
              <p:nvPr/>
            </p:nvSpPr>
            <p:spPr>
              <a:xfrm>
                <a:off x="863280" y="15391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264" name="Textfeld 263"/>
            <p:cNvSpPr txBox="1"/>
            <p:nvPr/>
          </p:nvSpPr>
          <p:spPr>
            <a:xfrm>
              <a:off x="1367336" y="6174741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265" name="Gruppieren 264"/>
            <p:cNvGrpSpPr/>
            <p:nvPr/>
          </p:nvGrpSpPr>
          <p:grpSpPr>
            <a:xfrm>
              <a:off x="1781120" y="6204358"/>
              <a:ext cx="486624" cy="261610"/>
              <a:chOff x="774000" y="1404000"/>
              <a:chExt cx="486624" cy="261610"/>
            </a:xfrm>
          </p:grpSpPr>
          <p:sp>
            <p:nvSpPr>
              <p:cNvPr id="266" name="Textfeld 265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67" name="Textfeld 266"/>
              <p:cNvSpPr txBox="1"/>
              <p:nvPr/>
            </p:nvSpPr>
            <p:spPr>
              <a:xfrm>
                <a:off x="864272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68" name="Gruppieren 267"/>
            <p:cNvGrpSpPr/>
            <p:nvPr/>
          </p:nvGrpSpPr>
          <p:grpSpPr>
            <a:xfrm>
              <a:off x="2195736" y="6204358"/>
              <a:ext cx="486624" cy="261610"/>
              <a:chOff x="774000" y="1404000"/>
              <a:chExt cx="486624" cy="261610"/>
            </a:xfrm>
          </p:grpSpPr>
          <p:sp>
            <p:nvSpPr>
              <p:cNvPr id="269" name="Textfeld 268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70" name="Textfeld 269"/>
              <p:cNvSpPr txBox="1"/>
              <p:nvPr/>
            </p:nvSpPr>
            <p:spPr>
              <a:xfrm>
                <a:off x="864272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71" name="Gruppieren 270"/>
            <p:cNvGrpSpPr/>
            <p:nvPr/>
          </p:nvGrpSpPr>
          <p:grpSpPr>
            <a:xfrm>
              <a:off x="2592016" y="5611887"/>
              <a:ext cx="497152" cy="621650"/>
              <a:chOff x="792872" y="1106350"/>
              <a:chExt cx="497152" cy="621650"/>
            </a:xfrm>
          </p:grpSpPr>
          <p:sp>
            <p:nvSpPr>
              <p:cNvPr id="272" name="Textfeld 271"/>
              <p:cNvSpPr txBox="1"/>
              <p:nvPr/>
            </p:nvSpPr>
            <p:spPr>
              <a:xfrm>
                <a:off x="792872" y="146639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73" name="Textfeld 272"/>
              <p:cNvSpPr txBox="1"/>
              <p:nvPr/>
            </p:nvSpPr>
            <p:spPr>
              <a:xfrm>
                <a:off x="893672" y="110635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74" name="Gruppieren 273"/>
            <p:cNvGrpSpPr/>
            <p:nvPr/>
          </p:nvGrpSpPr>
          <p:grpSpPr>
            <a:xfrm>
              <a:off x="3005256" y="6204358"/>
              <a:ext cx="486624" cy="261610"/>
              <a:chOff x="774000" y="1404000"/>
              <a:chExt cx="486624" cy="261610"/>
            </a:xfrm>
          </p:grpSpPr>
          <p:sp>
            <p:nvSpPr>
              <p:cNvPr id="275" name="Textfeld 274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76" name="Textfeld 275"/>
              <p:cNvSpPr txBox="1"/>
              <p:nvPr/>
            </p:nvSpPr>
            <p:spPr>
              <a:xfrm>
                <a:off x="864272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77" name="Gruppieren 276"/>
            <p:cNvGrpSpPr/>
            <p:nvPr/>
          </p:nvGrpSpPr>
          <p:grpSpPr>
            <a:xfrm>
              <a:off x="5868144" y="6204358"/>
              <a:ext cx="485632" cy="261610"/>
              <a:chOff x="774000" y="1404000"/>
              <a:chExt cx="485632" cy="261610"/>
            </a:xfrm>
          </p:grpSpPr>
          <p:sp>
            <p:nvSpPr>
              <p:cNvPr id="278" name="Textfeld 277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79" name="Textfeld 278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80" name="Gruppieren 279"/>
            <p:cNvGrpSpPr/>
            <p:nvPr/>
          </p:nvGrpSpPr>
          <p:grpSpPr>
            <a:xfrm>
              <a:off x="6300192" y="6204358"/>
              <a:ext cx="485632" cy="261610"/>
              <a:chOff x="774000" y="1404000"/>
              <a:chExt cx="485632" cy="261610"/>
            </a:xfrm>
          </p:grpSpPr>
          <p:sp>
            <p:nvSpPr>
              <p:cNvPr id="281" name="Textfeld 280"/>
              <p:cNvSpPr txBox="1"/>
              <p:nvPr/>
            </p:nvSpPr>
            <p:spPr>
              <a:xfrm>
                <a:off x="77400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82" name="Textfeld 281"/>
              <p:cNvSpPr txBox="1"/>
              <p:nvPr/>
            </p:nvSpPr>
            <p:spPr>
              <a:xfrm>
                <a:off x="863280" y="1404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283" name="Textfeld 282"/>
            <p:cNvSpPr txBox="1"/>
            <p:nvPr/>
          </p:nvSpPr>
          <p:spPr>
            <a:xfrm>
              <a:off x="8467216" y="5971927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285" name="Textfeld 284"/>
            <p:cNvSpPr txBox="1"/>
            <p:nvPr/>
          </p:nvSpPr>
          <p:spPr>
            <a:xfrm>
              <a:off x="954016" y="5297433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346364763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8</Words>
  <Application>Microsoft Office PowerPoint</Application>
  <PresentationFormat>Bildschirmpräsentation (4:3)</PresentationFormat>
  <Paragraphs>18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igand, Annika</dc:creator>
  <cp:lastModifiedBy>Weigand, Annika</cp:lastModifiedBy>
  <cp:revision>266</cp:revision>
  <cp:lastPrinted>2015-04-28T11:16:18Z</cp:lastPrinted>
  <dcterms:created xsi:type="dcterms:W3CDTF">2014-07-18T07:51:48Z</dcterms:created>
  <dcterms:modified xsi:type="dcterms:W3CDTF">2016-01-22T15:50:32Z</dcterms:modified>
</cp:coreProperties>
</file>